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311" r:id="rId2"/>
  </p:sldIdLst>
  <p:sldSz cx="10799763" cy="125999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 userDrawn="1">
          <p15:clr>
            <a:srgbClr val="A4A3A4"/>
          </p15:clr>
        </p15:guide>
        <p15:guide id="2" pos="340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E2720"/>
    <a:srgbClr val="2A241F"/>
    <a:srgbClr val="1B1713"/>
    <a:srgbClr val="0F0D0B"/>
    <a:srgbClr val="14110E"/>
    <a:srgbClr val="2C251F"/>
    <a:srgbClr val="302921"/>
    <a:srgbClr val="2B232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18603FDC-E32A-4AB5-989C-0864C3EAD2B8}" styleName="Themed Style 2 - Accent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76" autoAdjust="0"/>
    <p:restoredTop sz="95407" autoAdjust="0"/>
  </p:normalViewPr>
  <p:slideViewPr>
    <p:cSldViewPr snapToGrid="0">
      <p:cViewPr>
        <p:scale>
          <a:sx n="66" d="100"/>
          <a:sy n="66" d="100"/>
        </p:scale>
        <p:origin x="414" y="48"/>
      </p:cViewPr>
      <p:guideLst>
        <p:guide orient="horz" pos="3969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618487" cy="1618487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arga Kinga Edina" userId="70f79362-1689-4710-90f8-3ef476fdf0b2" providerId="ADAL" clId="{EBCFE07B-312A-46BE-A3A2-F7C5D73577C5}"/>
    <pc:docChg chg="undo custSel addSld delSld modSld">
      <pc:chgData name="Varga Kinga Edina" userId="70f79362-1689-4710-90f8-3ef476fdf0b2" providerId="ADAL" clId="{EBCFE07B-312A-46BE-A3A2-F7C5D73577C5}" dt="2023-04-17T15:29:35.143" v="10" actId="20577"/>
      <pc:docMkLst>
        <pc:docMk/>
      </pc:docMkLst>
      <pc:sldChg chg="del">
        <pc:chgData name="Varga Kinga Edina" userId="70f79362-1689-4710-90f8-3ef476fdf0b2" providerId="ADAL" clId="{EBCFE07B-312A-46BE-A3A2-F7C5D73577C5}" dt="2023-04-17T15:25:32.613" v="0" actId="2696"/>
        <pc:sldMkLst>
          <pc:docMk/>
          <pc:sldMk cId="3762773741" sldId="306"/>
        </pc:sldMkLst>
      </pc:sldChg>
      <pc:sldChg chg="del">
        <pc:chgData name="Varga Kinga Edina" userId="70f79362-1689-4710-90f8-3ef476fdf0b2" providerId="ADAL" clId="{EBCFE07B-312A-46BE-A3A2-F7C5D73577C5}" dt="2023-04-17T15:26:00.719" v="1" actId="2696"/>
        <pc:sldMkLst>
          <pc:docMk/>
          <pc:sldMk cId="2092552200" sldId="307"/>
        </pc:sldMkLst>
      </pc:sldChg>
      <pc:sldChg chg="add del">
        <pc:chgData name="Varga Kinga Edina" userId="70f79362-1689-4710-90f8-3ef476fdf0b2" providerId="ADAL" clId="{EBCFE07B-312A-46BE-A3A2-F7C5D73577C5}" dt="2023-04-17T15:28:31.226" v="8" actId="2696"/>
        <pc:sldMkLst>
          <pc:docMk/>
          <pc:sldMk cId="745039572" sldId="308"/>
        </pc:sldMkLst>
      </pc:sldChg>
      <pc:sldChg chg="del">
        <pc:chgData name="Varga Kinga Edina" userId="70f79362-1689-4710-90f8-3ef476fdf0b2" providerId="ADAL" clId="{EBCFE07B-312A-46BE-A3A2-F7C5D73577C5}" dt="2023-04-17T15:27:11.873" v="5" actId="2696"/>
        <pc:sldMkLst>
          <pc:docMk/>
          <pc:sldMk cId="2798529264" sldId="309"/>
        </pc:sldMkLst>
      </pc:sldChg>
      <pc:sldChg chg="del">
        <pc:chgData name="Varga Kinga Edina" userId="70f79362-1689-4710-90f8-3ef476fdf0b2" providerId="ADAL" clId="{EBCFE07B-312A-46BE-A3A2-F7C5D73577C5}" dt="2023-04-17T15:26:55.677" v="2" actId="2696"/>
        <pc:sldMkLst>
          <pc:docMk/>
          <pc:sldMk cId="1223200249" sldId="310"/>
        </pc:sldMkLst>
      </pc:sldChg>
      <pc:sldChg chg="modSp mod">
        <pc:chgData name="Varga Kinga Edina" userId="70f79362-1689-4710-90f8-3ef476fdf0b2" providerId="ADAL" clId="{EBCFE07B-312A-46BE-A3A2-F7C5D73577C5}" dt="2023-04-17T15:29:35.143" v="10" actId="20577"/>
        <pc:sldMkLst>
          <pc:docMk/>
          <pc:sldMk cId="1782387281" sldId="311"/>
        </pc:sldMkLst>
        <pc:graphicFrameChg chg="modGraphic">
          <ac:chgData name="Varga Kinga Edina" userId="70f79362-1689-4710-90f8-3ef476fdf0b2" providerId="ADAL" clId="{EBCFE07B-312A-46BE-A3A2-F7C5D73577C5}" dt="2023-04-17T15:29:35.143" v="10" actId="20577"/>
          <ac:graphicFrameMkLst>
            <pc:docMk/>
            <pc:sldMk cId="1782387281" sldId="311"/>
            <ac:graphicFrameMk id="12" creationId="{35A42593-0C7F-8C08-0F7E-2F9FB01F1904}"/>
          </ac:graphicFrameMkLst>
        </pc:graphicFrameChg>
      </pc:sldChg>
      <pc:sldChg chg="add del">
        <pc:chgData name="Varga Kinga Edina" userId="70f79362-1689-4710-90f8-3ef476fdf0b2" providerId="ADAL" clId="{EBCFE07B-312A-46BE-A3A2-F7C5D73577C5}" dt="2023-04-17T15:27:06.414" v="4" actId="2696"/>
        <pc:sldMkLst>
          <pc:docMk/>
          <pc:sldMk cId="1529075674" sldId="317"/>
        </pc:sldMkLst>
      </pc:sldChg>
    </pc:docChg>
  </pc:docChgLst>
  <pc:docChgLst>
    <pc:chgData name="Varga Kinga Edina" userId="70f79362-1689-4710-90f8-3ef476fdf0b2" providerId="ADAL" clId="{98DA693D-6EB7-4E2D-B1CE-678155A19660}"/>
    <pc:docChg chg="delSld modSld">
      <pc:chgData name="Varga Kinga Edina" userId="70f79362-1689-4710-90f8-3ef476fdf0b2" providerId="ADAL" clId="{98DA693D-6EB7-4E2D-B1CE-678155A19660}" dt="2023-03-09T11:50:00.192" v="10" actId="20577"/>
      <pc:docMkLst>
        <pc:docMk/>
      </pc:docMkLst>
      <pc:sldChg chg="modSp mod">
        <pc:chgData name="Varga Kinga Edina" userId="70f79362-1689-4710-90f8-3ef476fdf0b2" providerId="ADAL" clId="{98DA693D-6EB7-4E2D-B1CE-678155A19660}" dt="2023-03-09T11:50:00.192" v="10" actId="20577"/>
        <pc:sldMkLst>
          <pc:docMk/>
          <pc:sldMk cId="3762773741" sldId="306"/>
        </pc:sldMkLst>
        <pc:graphicFrameChg chg="modGraphic">
          <ac:chgData name="Varga Kinga Edina" userId="70f79362-1689-4710-90f8-3ef476fdf0b2" providerId="ADAL" clId="{98DA693D-6EB7-4E2D-B1CE-678155A19660}" dt="2023-03-09T11:50:00.192" v="10" actId="20577"/>
          <ac:graphicFrameMkLst>
            <pc:docMk/>
            <pc:sldMk cId="3762773741" sldId="306"/>
            <ac:graphicFrameMk id="12" creationId="{35A42593-0C7F-8C08-0F7E-2F9FB01F1904}"/>
          </ac:graphicFrameMkLst>
        </pc:graphicFrameChg>
      </pc:sldChg>
      <pc:sldChg chg="del">
        <pc:chgData name="Varga Kinga Edina" userId="70f79362-1689-4710-90f8-3ef476fdf0b2" providerId="ADAL" clId="{98DA693D-6EB7-4E2D-B1CE-678155A19660}" dt="2023-03-09T11:49:41.681" v="0" actId="2696"/>
        <pc:sldMkLst>
          <pc:docMk/>
          <pc:sldMk cId="1553807232" sldId="315"/>
        </pc:sldMkLst>
      </pc:sldChg>
    </pc:docChg>
  </pc:docChgLst>
  <pc:docChgLst>
    <pc:chgData name="Varga Kinga Edina" userId="70f79362-1689-4710-90f8-3ef476fdf0b2" providerId="ADAL" clId="{A49378CA-62C8-4F31-AE14-A88660022B6E}"/>
    <pc:docChg chg="delSld">
      <pc:chgData name="Varga Kinga Edina" userId="70f79362-1689-4710-90f8-3ef476fdf0b2" providerId="ADAL" clId="{A49378CA-62C8-4F31-AE14-A88660022B6E}" dt="2024-05-17T08:24:19.510" v="1" actId="2696"/>
      <pc:docMkLst>
        <pc:docMk/>
      </pc:docMkLst>
      <pc:sldChg chg="del">
        <pc:chgData name="Varga Kinga Edina" userId="70f79362-1689-4710-90f8-3ef476fdf0b2" providerId="ADAL" clId="{A49378CA-62C8-4F31-AE14-A88660022B6E}" dt="2024-05-17T08:24:19.510" v="1" actId="2696"/>
        <pc:sldMkLst>
          <pc:docMk/>
          <pc:sldMk cId="4164434808" sldId="313"/>
        </pc:sldMkLst>
      </pc:sldChg>
      <pc:sldChg chg="del">
        <pc:chgData name="Varga Kinga Edina" userId="70f79362-1689-4710-90f8-3ef476fdf0b2" providerId="ADAL" clId="{A49378CA-62C8-4F31-AE14-A88660022B6E}" dt="2024-05-17T07:47:25.827" v="0" actId="2696"/>
        <pc:sldMkLst>
          <pc:docMk/>
          <pc:sldMk cId="2233749773" sldId="314"/>
        </pc:sldMkLst>
      </pc:sldChg>
    </pc:docChg>
  </pc:docChgLst>
  <pc:docChgLst>
    <pc:chgData name="Varga Kinga Edina" userId="70f79362-1689-4710-90f8-3ef476fdf0b2" providerId="ADAL" clId="{E54B7B39-E2C1-4F73-A696-4EDA7F4A108E}"/>
    <pc:docChg chg="undo redo custSel addSld delSld modSld sldOrd">
      <pc:chgData name="Varga Kinga Edina" userId="70f79362-1689-4710-90f8-3ef476fdf0b2" providerId="ADAL" clId="{E54B7B39-E2C1-4F73-A696-4EDA7F4A108E}" dt="2023-04-17T15:21:58.069" v="2750"/>
      <pc:docMkLst>
        <pc:docMk/>
      </pc:docMkLst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3834314043" sldId="304"/>
        </pc:sldMkLst>
      </pc:sldChg>
      <pc:sldChg chg="addSp delSp modSp mod">
        <pc:chgData name="Varga Kinga Edina" userId="70f79362-1689-4710-90f8-3ef476fdf0b2" providerId="ADAL" clId="{E54B7B39-E2C1-4F73-A696-4EDA7F4A108E}" dt="2023-03-10T09:44:01.751" v="479" actId="1076"/>
        <pc:sldMkLst>
          <pc:docMk/>
          <pc:sldMk cId="3762773741" sldId="306"/>
        </pc:sldMkLst>
        <pc:grpChg chg="del">
          <ac:chgData name="Varga Kinga Edina" userId="70f79362-1689-4710-90f8-3ef476fdf0b2" providerId="ADAL" clId="{E54B7B39-E2C1-4F73-A696-4EDA7F4A108E}" dt="2023-03-09T13:12:51.184" v="37" actId="478"/>
          <ac:grpSpMkLst>
            <pc:docMk/>
            <pc:sldMk cId="3762773741" sldId="306"/>
            <ac:grpSpMk id="65" creationId="{9C2E491D-C1A5-B57B-5579-863C7BE54866}"/>
          </ac:grpSpMkLst>
        </pc:grpChg>
        <pc:grpChg chg="add mod">
          <ac:chgData name="Varga Kinga Edina" userId="70f79362-1689-4710-90f8-3ef476fdf0b2" providerId="ADAL" clId="{E54B7B39-E2C1-4F73-A696-4EDA7F4A108E}" dt="2023-03-10T09:44:01.751" v="479" actId="1076"/>
          <ac:grpSpMkLst>
            <pc:docMk/>
            <pc:sldMk cId="3762773741" sldId="306"/>
            <ac:grpSpMk id="88" creationId="{A4AD4EC8-E4BB-5222-2BD5-48CF3ED4BC62}"/>
          </ac:grpSpMkLst>
        </pc:grpChg>
        <pc:graphicFrameChg chg="mod modGraphic">
          <ac:chgData name="Varga Kinga Edina" userId="70f79362-1689-4710-90f8-3ef476fdf0b2" providerId="ADAL" clId="{E54B7B39-E2C1-4F73-A696-4EDA7F4A108E}" dt="2023-03-09T13:43:52.615" v="347"/>
          <ac:graphicFrameMkLst>
            <pc:docMk/>
            <pc:sldMk cId="3762773741" sldId="306"/>
            <ac:graphicFrameMk id="12" creationId="{35A42593-0C7F-8C08-0F7E-2F9FB01F1904}"/>
          </ac:graphicFrameMkLst>
        </pc:graphicFrame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3" creationId="{229762A0-292F-C6E8-81F1-B8D44A4EC291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7" creationId="{47530755-FB26-0CEA-2A56-52379C585F76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11" creationId="{A4FEC95D-0AA6-20FA-F778-6CA931877EDE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14" creationId="{023DA702-5F95-E88A-2824-8A79D35CEA16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16" creationId="{398BB5F3-7E8E-0565-BAFE-F36163C6ACE6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18" creationId="{D67CFC26-104D-035B-4B6D-5C57E96B577B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20" creationId="{A99700E7-6B9D-5DCE-F642-52B097EC73C1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22" creationId="{D66781ED-0690-3BCE-8D1C-891BBCC6A376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24" creationId="{3A698FDA-20F3-DB8B-9C4C-3AAADB280E9D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26" creationId="{904A760B-E95F-A469-E6F3-20842C60F9F9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28" creationId="{042F9348-FB02-4BCC-A0D1-C4A88BD95A32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30" creationId="{CF713BBF-A382-0BC9-E961-506BAFDBEFC8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32" creationId="{57C26AFC-3D6D-12E9-7112-DE8736F17203}"/>
          </ac:picMkLst>
        </pc:picChg>
        <pc:picChg chg="add del mod">
          <ac:chgData name="Varga Kinga Edina" userId="70f79362-1689-4710-90f8-3ef476fdf0b2" providerId="ADAL" clId="{E54B7B39-E2C1-4F73-A696-4EDA7F4A108E}" dt="2023-03-09T13:26:59.042" v="215" actId="478"/>
          <ac:picMkLst>
            <pc:docMk/>
            <pc:sldMk cId="3762773741" sldId="306"/>
            <ac:picMk id="35" creationId="{E65AF6A3-8306-77AD-D5A7-70A4E605AE5B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39" creationId="{1923650C-6162-9F40-D734-2704EBBCC96F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43" creationId="{0D612A3D-AF82-650D-C063-497299095114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47" creationId="{35499A9D-8FAF-1B78-C624-1799F320447A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51" creationId="{F9F771C1-3F41-2F3F-9948-4DC8489A8FEA}"/>
          </ac:picMkLst>
        </pc:picChg>
        <pc:picChg chg="add del mod">
          <ac:chgData name="Varga Kinga Edina" userId="70f79362-1689-4710-90f8-3ef476fdf0b2" providerId="ADAL" clId="{E54B7B39-E2C1-4F73-A696-4EDA7F4A108E}" dt="2023-03-09T13:31:43.509" v="252" actId="478"/>
          <ac:picMkLst>
            <pc:docMk/>
            <pc:sldMk cId="3762773741" sldId="306"/>
            <ac:picMk id="55" creationId="{8EBCFD30-5FB9-12E2-2799-F794E7BCD0C6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59" creationId="{43267EEA-A506-B5AF-3CCF-2B4460581813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63" creationId="{D4EFF17A-3F7D-04BF-8099-9DA89E9B24D6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67" creationId="{C6C0A0A1-7CF0-DE06-8EC8-A14A8F5B1A90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69" creationId="{EAB72610-7FE4-186F-56ED-8ECAC3F0794B}"/>
          </ac:picMkLst>
        </pc:picChg>
        <pc:picChg chg="add del mod">
          <ac:chgData name="Varga Kinga Edina" userId="70f79362-1689-4710-90f8-3ef476fdf0b2" providerId="ADAL" clId="{E54B7B39-E2C1-4F73-A696-4EDA7F4A108E}" dt="2023-03-09T13:33:56.790" v="283"/>
          <ac:picMkLst>
            <pc:docMk/>
            <pc:sldMk cId="3762773741" sldId="306"/>
            <ac:picMk id="71" creationId="{4597787A-F031-86C3-BE93-6BEC79F094ED}"/>
          </ac:picMkLst>
        </pc:picChg>
        <pc:picChg chg="add del mod">
          <ac:chgData name="Varga Kinga Edina" userId="70f79362-1689-4710-90f8-3ef476fdf0b2" providerId="ADAL" clId="{E54B7B39-E2C1-4F73-A696-4EDA7F4A108E}" dt="2023-03-09T13:34:01.586" v="285"/>
          <ac:picMkLst>
            <pc:docMk/>
            <pc:sldMk cId="3762773741" sldId="306"/>
            <ac:picMk id="73" creationId="{0CB58787-E3AD-B958-D453-F1D4A2CD2AFC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75" creationId="{236EF470-6156-82A0-EB99-E47EF082168E}"/>
          </ac:picMkLst>
        </pc:picChg>
        <pc:picChg chg="add mod modCrop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77" creationId="{EDF5B3E1-CC17-2BC0-32F3-CCA46A7A48AA}"/>
          </ac:picMkLst>
        </pc:picChg>
        <pc:picChg chg="add del mod">
          <ac:chgData name="Varga Kinga Edina" userId="70f79362-1689-4710-90f8-3ef476fdf0b2" providerId="ADAL" clId="{E54B7B39-E2C1-4F73-A696-4EDA7F4A108E}" dt="2023-03-09T13:35:31.111" v="302"/>
          <ac:picMkLst>
            <pc:docMk/>
            <pc:sldMk cId="3762773741" sldId="306"/>
            <ac:picMk id="79" creationId="{2696980C-04BE-473B-370E-2F9BFC57F6DE}"/>
          </ac:picMkLst>
        </pc:picChg>
        <pc:picChg chg="add del mod">
          <ac:chgData name="Varga Kinga Edina" userId="70f79362-1689-4710-90f8-3ef476fdf0b2" providerId="ADAL" clId="{E54B7B39-E2C1-4F73-A696-4EDA7F4A108E}" dt="2023-03-09T13:35:47.591" v="306"/>
          <ac:picMkLst>
            <pc:docMk/>
            <pc:sldMk cId="3762773741" sldId="306"/>
            <ac:picMk id="80" creationId="{E4D7AD99-4B67-D7E6-B39D-1D8BBF512DB0}"/>
          </ac:picMkLst>
        </pc:picChg>
        <pc:picChg chg="add del mod">
          <ac:chgData name="Varga Kinga Edina" userId="70f79362-1689-4710-90f8-3ef476fdf0b2" providerId="ADAL" clId="{E54B7B39-E2C1-4F73-A696-4EDA7F4A108E}" dt="2023-03-09T13:35:52.777" v="308"/>
          <ac:picMkLst>
            <pc:docMk/>
            <pc:sldMk cId="3762773741" sldId="306"/>
            <ac:picMk id="82" creationId="{85F96517-5C9D-8B91-99AC-7BE4AC22D52E}"/>
          </ac:picMkLst>
        </pc:picChg>
        <pc:picChg chg="add del mod">
          <ac:chgData name="Varga Kinga Edina" userId="70f79362-1689-4710-90f8-3ef476fdf0b2" providerId="ADAL" clId="{E54B7B39-E2C1-4F73-A696-4EDA7F4A108E}" dt="2023-03-09T13:35:58.737" v="310"/>
          <ac:picMkLst>
            <pc:docMk/>
            <pc:sldMk cId="3762773741" sldId="306"/>
            <ac:picMk id="84" creationId="{6AF89991-261B-D178-3362-73B1622AA975}"/>
          </ac:picMkLst>
        </pc:picChg>
        <pc:picChg chg="add del mod">
          <ac:chgData name="Varga Kinga Edina" userId="70f79362-1689-4710-90f8-3ef476fdf0b2" providerId="ADAL" clId="{E54B7B39-E2C1-4F73-A696-4EDA7F4A108E}" dt="2023-03-09T13:36:01.515" v="312"/>
          <ac:picMkLst>
            <pc:docMk/>
            <pc:sldMk cId="3762773741" sldId="306"/>
            <ac:picMk id="86" creationId="{1209B579-1183-1CBA-391B-34D8E8246E57}"/>
          </ac:picMkLst>
        </pc:picChg>
        <pc:picChg chg="add mod">
          <ac:chgData name="Varga Kinga Edina" userId="70f79362-1689-4710-90f8-3ef476fdf0b2" providerId="ADAL" clId="{E54B7B39-E2C1-4F73-A696-4EDA7F4A108E}" dt="2023-03-09T13:41:03.646" v="341" actId="164"/>
          <ac:picMkLst>
            <pc:docMk/>
            <pc:sldMk cId="3762773741" sldId="306"/>
            <ac:picMk id="87" creationId="{B79C0BF0-580C-4399-392D-5F1448BDF8F9}"/>
          </ac:picMkLst>
        </pc:picChg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1496664110" sldId="307"/>
        </pc:sldMkLst>
      </pc:sldChg>
      <pc:sldChg chg="addSp modSp add mod">
        <pc:chgData name="Varga Kinga Edina" userId="70f79362-1689-4710-90f8-3ef476fdf0b2" providerId="ADAL" clId="{E54B7B39-E2C1-4F73-A696-4EDA7F4A108E}" dt="2023-03-09T13:59:59.079" v="477"/>
        <pc:sldMkLst>
          <pc:docMk/>
          <pc:sldMk cId="2092552200" sldId="307"/>
        </pc:sldMkLst>
        <pc:grpChg chg="add mod">
          <ac:chgData name="Varga Kinga Edina" userId="70f79362-1689-4710-90f8-3ef476fdf0b2" providerId="ADAL" clId="{E54B7B39-E2C1-4F73-A696-4EDA7F4A108E}" dt="2023-03-09T13:59:46.124" v="476" actId="1076"/>
          <ac:grpSpMkLst>
            <pc:docMk/>
            <pc:sldMk cId="2092552200" sldId="307"/>
            <ac:grpSpMk id="27" creationId="{D58B818A-B0C5-D74F-6E51-42952624E3EA}"/>
          </ac:grpSpMkLst>
        </pc:grpChg>
        <pc:graphicFrameChg chg="mod modGraphic">
          <ac:chgData name="Varga Kinga Edina" userId="70f79362-1689-4710-90f8-3ef476fdf0b2" providerId="ADAL" clId="{E54B7B39-E2C1-4F73-A696-4EDA7F4A108E}" dt="2023-03-09T13:59:59.079" v="477"/>
          <ac:graphicFrameMkLst>
            <pc:docMk/>
            <pc:sldMk cId="2092552200" sldId="307"/>
            <ac:graphicFrameMk id="12" creationId="{35A42593-0C7F-8C08-0F7E-2F9FB01F1904}"/>
          </ac:graphicFrameMkLst>
        </pc:graphicFrame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3" creationId="{8FB106F9-2EDC-46FD-593B-8DA88B308CCE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5" creationId="{761CAA46-9D24-C1FF-61B7-323888E0CE11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7" creationId="{205EF4AF-DD0C-27C8-362F-C695F35439C3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9" creationId="{F669305D-169A-4309-3CB9-5B38B3A0F1E5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11" creationId="{2DCFE96E-DCF9-A221-D700-C6FBAF32DB4B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14" creationId="{38A06136-E0B6-8A4D-714D-BF6D0FE20E46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16" creationId="{6BA06633-F83E-17DA-DE6B-431B182B3EE7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18" creationId="{13CB107F-CA2A-C7B6-2209-88A505B51A75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20" creationId="{7BDACF49-0EDA-5D9F-A172-E8F853B71B52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22" creationId="{C678C3AE-AC11-0BA9-329A-CECF25D9FEE6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24" creationId="{5173F8D1-8A76-B754-D7DC-FBDFC89B306A}"/>
          </ac:picMkLst>
        </pc:picChg>
        <pc:picChg chg="add mod modCrop">
          <ac:chgData name="Varga Kinga Edina" userId="70f79362-1689-4710-90f8-3ef476fdf0b2" providerId="ADAL" clId="{E54B7B39-E2C1-4F73-A696-4EDA7F4A108E}" dt="2023-03-09T13:59:33.180" v="474" actId="164"/>
          <ac:picMkLst>
            <pc:docMk/>
            <pc:sldMk cId="2092552200" sldId="307"/>
            <ac:picMk id="26" creationId="{59755A93-39F6-6F1D-44E5-B66C7414FF66}"/>
          </ac:picMkLst>
        </pc:picChg>
      </pc:sldChg>
      <pc:sldChg chg="addSp delSp modSp add mod">
        <pc:chgData name="Varga Kinga Edina" userId="70f79362-1689-4710-90f8-3ef476fdf0b2" providerId="ADAL" clId="{E54B7B39-E2C1-4F73-A696-4EDA7F4A108E}" dt="2023-03-13T14:07:36.592" v="839" actId="1076"/>
        <pc:sldMkLst>
          <pc:docMk/>
          <pc:sldMk cId="745039572" sldId="308"/>
        </pc:sldMkLst>
        <pc:grpChg chg="del">
          <ac:chgData name="Varga Kinga Edina" userId="70f79362-1689-4710-90f8-3ef476fdf0b2" providerId="ADAL" clId="{E54B7B39-E2C1-4F73-A696-4EDA7F4A108E}" dt="2023-03-13T12:19:44.942" v="481" actId="478"/>
          <ac:grpSpMkLst>
            <pc:docMk/>
            <pc:sldMk cId="745039572" sldId="308"/>
            <ac:grpSpMk id="27" creationId="{D58B818A-B0C5-D74F-6E51-42952624E3EA}"/>
          </ac:grpSpMkLst>
        </pc:grpChg>
        <pc:grpChg chg="add mod">
          <ac:chgData name="Varga Kinga Edina" userId="70f79362-1689-4710-90f8-3ef476fdf0b2" providerId="ADAL" clId="{E54B7B39-E2C1-4F73-A696-4EDA7F4A108E}" dt="2023-03-13T14:07:14.929" v="834" actId="164"/>
          <ac:grpSpMkLst>
            <pc:docMk/>
            <pc:sldMk cId="745039572" sldId="308"/>
            <ac:grpSpMk id="63" creationId="{9B45D5DE-66D3-725A-B124-B881C658D194}"/>
          </ac:grpSpMkLst>
        </pc:grpChg>
        <pc:grpChg chg="add mod">
          <ac:chgData name="Varga Kinga Edina" userId="70f79362-1689-4710-90f8-3ef476fdf0b2" providerId="ADAL" clId="{E54B7B39-E2C1-4F73-A696-4EDA7F4A108E}" dt="2023-03-13T14:07:36.592" v="839" actId="1076"/>
          <ac:grpSpMkLst>
            <pc:docMk/>
            <pc:sldMk cId="745039572" sldId="308"/>
            <ac:grpSpMk id="64" creationId="{B344D44A-12FF-09DC-884F-37D34FDB2068}"/>
          </ac:grpSpMkLst>
        </pc:grpChg>
        <pc:graphicFrameChg chg="mod modGraphic">
          <ac:chgData name="Varga Kinga Edina" userId="70f79362-1689-4710-90f8-3ef476fdf0b2" providerId="ADAL" clId="{E54B7B39-E2C1-4F73-A696-4EDA7F4A108E}" dt="2023-03-13T12:59:17.406" v="682" actId="14734"/>
          <ac:graphicFrameMkLst>
            <pc:docMk/>
            <pc:sldMk cId="745039572" sldId="308"/>
            <ac:graphicFrameMk id="12" creationId="{35A42593-0C7F-8C08-0F7E-2F9FB01F1904}"/>
          </ac:graphicFrameMkLst>
        </pc:graphicFrame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2" creationId="{2D368722-DBCA-E79F-86FF-A9319EB7EFAB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4" creationId="{9B539AC5-E1E0-1750-0A92-191E76DD4595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6" creationId="{260D5512-0AC1-B3A8-F8EC-5997BD7532B3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8" creationId="{7ADB3912-B5CB-6A2D-20FF-4FD1ACA34EDA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10" creationId="{F48F2DA7-FBE9-FAF0-482E-FA4A5B058352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15" creationId="{1804CC53-2ABF-1AD7-046A-DF35360F85AE}"/>
          </ac:picMkLst>
        </pc:picChg>
        <pc:picChg chg="add mod modCrop">
          <ac:chgData name="Varga Kinga Edina" userId="70f79362-1689-4710-90f8-3ef476fdf0b2" providerId="ADAL" clId="{E54B7B39-E2C1-4F73-A696-4EDA7F4A108E}" dt="2023-03-13T14:07:28.246" v="838" actId="1076"/>
          <ac:picMkLst>
            <pc:docMk/>
            <pc:sldMk cId="745039572" sldId="308"/>
            <ac:picMk id="19" creationId="{085F1D4E-AEA9-2FD6-BB61-1B22642BB8B0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23" creationId="{77A2DE96-3DA5-FDB0-4F39-443D07770A00}"/>
          </ac:picMkLst>
        </pc:picChg>
        <pc:picChg chg="add mod modCrop">
          <ac:chgData name="Varga Kinga Edina" userId="70f79362-1689-4710-90f8-3ef476fdf0b2" providerId="ADAL" clId="{E54B7B39-E2C1-4F73-A696-4EDA7F4A108E}" dt="2023-03-13T14:07:28.246" v="838" actId="1076"/>
          <ac:picMkLst>
            <pc:docMk/>
            <pc:sldMk cId="745039572" sldId="308"/>
            <ac:picMk id="28" creationId="{4C929159-CF1A-D6B2-B083-E520E2550BE7}"/>
          </ac:picMkLst>
        </pc:picChg>
        <pc:picChg chg="add mod modCrop">
          <ac:chgData name="Varga Kinga Edina" userId="70f79362-1689-4710-90f8-3ef476fdf0b2" providerId="ADAL" clId="{E54B7B39-E2C1-4F73-A696-4EDA7F4A108E}" dt="2023-03-13T14:07:28.246" v="838" actId="1076"/>
          <ac:picMkLst>
            <pc:docMk/>
            <pc:sldMk cId="745039572" sldId="308"/>
            <ac:picMk id="30" creationId="{8E9F8F9D-B82E-6AB5-7047-9521D055FDBD}"/>
          </ac:picMkLst>
        </pc:picChg>
        <pc:picChg chg="add mod modCrop">
          <ac:chgData name="Varga Kinga Edina" userId="70f79362-1689-4710-90f8-3ef476fdf0b2" providerId="ADAL" clId="{E54B7B39-E2C1-4F73-A696-4EDA7F4A108E}" dt="2023-03-13T14:07:28.246" v="838" actId="1076"/>
          <ac:picMkLst>
            <pc:docMk/>
            <pc:sldMk cId="745039572" sldId="308"/>
            <ac:picMk id="32" creationId="{18369237-B9CA-4FB9-6629-38027266377A}"/>
          </ac:picMkLst>
        </pc:picChg>
        <pc:picChg chg="add mod modCrop">
          <ac:chgData name="Varga Kinga Edina" userId="70f79362-1689-4710-90f8-3ef476fdf0b2" providerId="ADAL" clId="{E54B7B39-E2C1-4F73-A696-4EDA7F4A108E}" dt="2023-03-13T14:07:28.246" v="838" actId="1076"/>
          <ac:picMkLst>
            <pc:docMk/>
            <pc:sldMk cId="745039572" sldId="308"/>
            <ac:picMk id="34" creationId="{D20C1429-E60C-6B03-66C2-957C79F7B59C}"/>
          </ac:picMkLst>
        </pc:picChg>
        <pc:picChg chg="add del mod">
          <ac:chgData name="Varga Kinga Edina" userId="70f79362-1689-4710-90f8-3ef476fdf0b2" providerId="ADAL" clId="{E54B7B39-E2C1-4F73-A696-4EDA7F4A108E}" dt="2023-03-13T13:06:29.390" v="707" actId="478"/>
          <ac:picMkLst>
            <pc:docMk/>
            <pc:sldMk cId="745039572" sldId="308"/>
            <ac:picMk id="36" creationId="{5E419F59-3EF4-6CF3-ED50-563B32DBB3C9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38" creationId="{7840C589-F6DD-465C-E580-A9575166A8BD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40" creationId="{2BEF677D-026A-A3FB-B819-C3E366053FB4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42" creationId="{24D821FB-41CE-D8AE-7B00-3C6C7969D836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44" creationId="{AA690408-F5D8-ACA8-FDE2-BE5188A4844F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46" creationId="{BC1C2D64-C2BE-CD1E-0823-E7825472ECFF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48" creationId="{477117D5-D953-F07A-EFF8-BA319A042C76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0" creationId="{1A9E8A8D-EBBB-BA8F-62AC-4EABD818A994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2" creationId="{EF2094E3-62B3-DAEB-03AB-BF5842A4DA3B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4" creationId="{95A108C4-B2E4-DE86-789D-69A5ED460506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5" creationId="{E879D877-BED4-B15B-7609-B6B5540A6F5F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6" creationId="{E8832524-E828-9486-26DE-2C2589E7C628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7" creationId="{9C8B13D5-70E2-4812-14D8-B1F68093FEA9}"/>
          </ac:picMkLst>
        </pc:picChg>
        <pc:picChg chg="add mod modCrop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59" creationId="{3C664ABF-34F7-5C3B-1BE9-6AB6C9F4EB9F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60" creationId="{7EDC05B7-C6CD-FC37-9DB4-08495464DF12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61" creationId="{E8298EF8-509E-A073-827E-343D12CDAF95}"/>
          </ac:picMkLst>
        </pc:picChg>
        <pc:picChg chg="add mod">
          <ac:chgData name="Varga Kinga Edina" userId="70f79362-1689-4710-90f8-3ef476fdf0b2" providerId="ADAL" clId="{E54B7B39-E2C1-4F73-A696-4EDA7F4A108E}" dt="2023-03-13T14:06:58.433" v="831" actId="164"/>
          <ac:picMkLst>
            <pc:docMk/>
            <pc:sldMk cId="745039572" sldId="308"/>
            <ac:picMk id="62" creationId="{80043326-5D77-2F5B-9B35-AD830CF2EA8D}"/>
          </ac:picMkLst>
        </pc:picChg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3524621486" sldId="308"/>
        </pc:sldMkLst>
      </pc:sldChg>
      <pc:sldChg chg="addSp delSp modSp add mod">
        <pc:chgData name="Varga Kinga Edina" userId="70f79362-1689-4710-90f8-3ef476fdf0b2" providerId="ADAL" clId="{E54B7B39-E2C1-4F73-A696-4EDA7F4A108E}" dt="2023-03-13T14:17:18.193" v="951"/>
        <pc:sldMkLst>
          <pc:docMk/>
          <pc:sldMk cId="2798529264" sldId="309"/>
        </pc:sldMkLst>
        <pc:grpChg chg="add mod">
          <ac:chgData name="Varga Kinga Edina" userId="70f79362-1689-4710-90f8-3ef476fdf0b2" providerId="ADAL" clId="{E54B7B39-E2C1-4F73-A696-4EDA7F4A108E}" dt="2023-03-13T14:17:10.814" v="950" actId="1076"/>
          <ac:grpSpMkLst>
            <pc:docMk/>
            <pc:sldMk cId="2798529264" sldId="309"/>
            <ac:grpSpMk id="33" creationId="{043471DB-D74B-85FA-57F5-AEC53032A20C}"/>
          </ac:grpSpMkLst>
        </pc:grpChg>
        <pc:graphicFrameChg chg="mod modGraphic">
          <ac:chgData name="Varga Kinga Edina" userId="70f79362-1689-4710-90f8-3ef476fdf0b2" providerId="ADAL" clId="{E54B7B39-E2C1-4F73-A696-4EDA7F4A108E}" dt="2023-03-13T14:17:18.193" v="951"/>
          <ac:graphicFrameMkLst>
            <pc:docMk/>
            <pc:sldMk cId="2798529264" sldId="309"/>
            <ac:graphicFrameMk id="12" creationId="{35A42593-0C7F-8C08-0F7E-2F9FB01F1904}"/>
          </ac:graphicFrameMkLst>
        </pc:graphicFrameChg>
        <pc:picChg chg="add del mod modCrop">
          <ac:chgData name="Varga Kinga Edina" userId="70f79362-1689-4710-90f8-3ef476fdf0b2" providerId="ADAL" clId="{E54B7B39-E2C1-4F73-A696-4EDA7F4A108E}" dt="2023-03-13T12:51:11.029" v="651" actId="21"/>
          <ac:picMkLst>
            <pc:docMk/>
            <pc:sldMk cId="2798529264" sldId="309"/>
            <ac:picMk id="3" creationId="{06FBC2EE-C149-B6C4-3E0F-94CC235B5B77}"/>
          </ac:picMkLst>
        </pc:picChg>
        <pc:picChg chg="add del mod modCrop">
          <ac:chgData name="Varga Kinga Edina" userId="70f79362-1689-4710-90f8-3ef476fdf0b2" providerId="ADAL" clId="{E54B7B39-E2C1-4F73-A696-4EDA7F4A108E}" dt="2023-03-13T12:51:11.029" v="651" actId="21"/>
          <ac:picMkLst>
            <pc:docMk/>
            <pc:sldMk cId="2798529264" sldId="309"/>
            <ac:picMk id="5" creationId="{BBF57BCC-842A-C0B3-86DB-DD9357F5B6F9}"/>
          </ac:picMkLst>
        </pc:picChg>
        <pc:picChg chg="add del mod modCrop">
          <ac:chgData name="Varga Kinga Edina" userId="70f79362-1689-4710-90f8-3ef476fdf0b2" providerId="ADAL" clId="{E54B7B39-E2C1-4F73-A696-4EDA7F4A108E}" dt="2023-03-13T12:51:11.029" v="651" actId="21"/>
          <ac:picMkLst>
            <pc:docMk/>
            <pc:sldMk cId="2798529264" sldId="309"/>
            <ac:picMk id="7" creationId="{DD4E0DA1-5B2E-3D98-C733-F7DAA053C57B}"/>
          </ac:picMkLst>
        </pc:picChg>
        <pc:picChg chg="add del mod modCrop">
          <ac:chgData name="Varga Kinga Edina" userId="70f79362-1689-4710-90f8-3ef476fdf0b2" providerId="ADAL" clId="{E54B7B39-E2C1-4F73-A696-4EDA7F4A108E}" dt="2023-03-13T12:51:11.029" v="651" actId="21"/>
          <ac:picMkLst>
            <pc:docMk/>
            <pc:sldMk cId="2798529264" sldId="309"/>
            <ac:picMk id="9" creationId="{B825A38D-0761-2DFE-5688-608FB9293ED0}"/>
          </ac:picMkLst>
        </pc:picChg>
        <pc:picChg chg="add del mod modCrop">
          <ac:chgData name="Varga Kinga Edina" userId="70f79362-1689-4710-90f8-3ef476fdf0b2" providerId="ADAL" clId="{E54B7B39-E2C1-4F73-A696-4EDA7F4A108E}" dt="2023-03-13T12:51:11.029" v="651" actId="21"/>
          <ac:picMkLst>
            <pc:docMk/>
            <pc:sldMk cId="2798529264" sldId="309"/>
            <ac:picMk id="11" creationId="{CD4AE554-94BA-0CAE-2EC2-8392146BBA92}"/>
          </ac:picMkLst>
        </pc:picChg>
        <pc:picChg chg="add mod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13" creationId="{82782C09-8930-7AD7-89C5-3A5E27226D4B}"/>
          </ac:picMkLst>
        </pc:picChg>
        <pc:picChg chg="add mod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14" creationId="{54F9A6CE-E9E4-736D-3D1D-25AE72686098}"/>
          </ac:picMkLst>
        </pc:picChg>
        <pc:picChg chg="add mod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15" creationId="{42DF22C1-4A9F-58AB-F5EA-61BF371DA99E}"/>
          </ac:picMkLst>
        </pc:picChg>
        <pc:picChg chg="add mod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16" creationId="{41B8DB69-1AF2-8A7B-AB3D-3C9859DEB161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18" creationId="{C8DBFCC9-605A-9136-71A8-316E822EA06C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20" creationId="{15462119-0C54-CDC5-E67C-DDEFE0D1ED3B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22" creationId="{A8C81F63-7899-B23E-3B8C-EA402C03B9B0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24" creationId="{4C0B9DB0-BAA2-459D-6CBF-47983CE3B0B6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26" creationId="{D08A90D5-911A-0A36-12B4-249D0527E457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28" creationId="{2ECE71FA-F143-01FD-876A-85870273AB80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30" creationId="{060F274C-A160-3026-2D42-A43B714B97CF}"/>
          </ac:picMkLst>
        </pc:picChg>
        <pc:picChg chg="add mod modCrop">
          <ac:chgData name="Varga Kinga Edina" userId="70f79362-1689-4710-90f8-3ef476fdf0b2" providerId="ADAL" clId="{E54B7B39-E2C1-4F73-A696-4EDA7F4A108E}" dt="2023-03-13T14:16:25.267" v="945" actId="164"/>
          <ac:picMkLst>
            <pc:docMk/>
            <pc:sldMk cId="2798529264" sldId="309"/>
            <ac:picMk id="32" creationId="{C413B819-6417-1193-B42A-A65658CC1347}"/>
          </ac:picMkLst>
        </pc:picChg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3650049192" sldId="309"/>
        </pc:sldMkLst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717828339" sldId="310"/>
        </pc:sldMkLst>
      </pc:sldChg>
      <pc:sldChg chg="addSp delSp modSp add mod">
        <pc:chgData name="Varga Kinga Edina" userId="70f79362-1689-4710-90f8-3ef476fdf0b2" providerId="ADAL" clId="{E54B7B39-E2C1-4F73-A696-4EDA7F4A108E}" dt="2023-03-14T08:37:29.813" v="1272" actId="20577"/>
        <pc:sldMkLst>
          <pc:docMk/>
          <pc:sldMk cId="1223200249" sldId="310"/>
        </pc:sldMkLst>
        <pc:grpChg chg="del">
          <ac:chgData name="Varga Kinga Edina" userId="70f79362-1689-4710-90f8-3ef476fdf0b2" providerId="ADAL" clId="{E54B7B39-E2C1-4F73-A696-4EDA7F4A108E}" dt="2023-03-13T14:17:28.772" v="953" actId="478"/>
          <ac:grpSpMkLst>
            <pc:docMk/>
            <pc:sldMk cId="1223200249" sldId="310"/>
            <ac:grpSpMk id="33" creationId="{043471DB-D74B-85FA-57F5-AEC53032A20C}"/>
          </ac:grpSpMkLst>
        </pc:grpChg>
        <pc:grpChg chg="add mod">
          <ac:chgData name="Varga Kinga Edina" userId="70f79362-1689-4710-90f8-3ef476fdf0b2" providerId="ADAL" clId="{E54B7B39-E2C1-4F73-A696-4EDA7F4A108E}" dt="2023-03-14T08:31:47.267" v="1265" actId="1076"/>
          <ac:grpSpMkLst>
            <pc:docMk/>
            <pc:sldMk cId="1223200249" sldId="310"/>
            <ac:grpSpMk id="72" creationId="{45484852-01E0-7CA8-805E-82CEF6516FBB}"/>
          </ac:grpSpMkLst>
        </pc:grpChg>
        <pc:graphicFrameChg chg="mod modGraphic">
          <ac:chgData name="Varga Kinga Edina" userId="70f79362-1689-4710-90f8-3ef476fdf0b2" providerId="ADAL" clId="{E54B7B39-E2C1-4F73-A696-4EDA7F4A108E}" dt="2023-03-14T08:37:29.813" v="1272" actId="20577"/>
          <ac:graphicFrameMkLst>
            <pc:docMk/>
            <pc:sldMk cId="1223200249" sldId="310"/>
            <ac:graphicFrameMk id="12" creationId="{35A42593-0C7F-8C08-0F7E-2F9FB01F1904}"/>
          </ac:graphicFrameMkLst>
        </pc:graphicFrameChg>
        <pc:picChg chg="add del mod">
          <ac:chgData name="Varga Kinga Edina" userId="70f79362-1689-4710-90f8-3ef476fdf0b2" providerId="ADAL" clId="{E54B7B39-E2C1-4F73-A696-4EDA7F4A108E}" dt="2023-03-13T14:35:02.682" v="1072" actId="478"/>
          <ac:picMkLst>
            <pc:docMk/>
            <pc:sldMk cId="1223200249" sldId="310"/>
            <ac:picMk id="2" creationId="{CE41122C-EB4C-6878-6382-EF97109A73FA}"/>
          </ac:picMkLst>
        </pc:picChg>
        <pc:picChg chg="add del mod">
          <ac:chgData name="Varga Kinga Edina" userId="70f79362-1689-4710-90f8-3ef476fdf0b2" providerId="ADAL" clId="{E54B7B39-E2C1-4F73-A696-4EDA7F4A108E}" dt="2023-03-13T14:35:03.055" v="1073" actId="478"/>
          <ac:picMkLst>
            <pc:docMk/>
            <pc:sldMk cId="1223200249" sldId="310"/>
            <ac:picMk id="3" creationId="{102F9895-850C-F59C-46EE-9B21E1B35D97}"/>
          </ac:picMkLst>
        </pc:picChg>
        <pc:picChg chg="add del mod">
          <ac:chgData name="Varga Kinga Edina" userId="70f79362-1689-4710-90f8-3ef476fdf0b2" providerId="ADAL" clId="{E54B7B39-E2C1-4F73-A696-4EDA7F4A108E}" dt="2023-03-13T14:35:03.442" v="1074" actId="478"/>
          <ac:picMkLst>
            <pc:docMk/>
            <pc:sldMk cId="1223200249" sldId="310"/>
            <ac:picMk id="4" creationId="{1125D27C-00E9-D2C1-3F9D-2B4F7A821682}"/>
          </ac:picMkLst>
        </pc:picChg>
        <pc:picChg chg="add del mod">
          <ac:chgData name="Varga Kinga Edina" userId="70f79362-1689-4710-90f8-3ef476fdf0b2" providerId="ADAL" clId="{E54B7B39-E2C1-4F73-A696-4EDA7F4A108E}" dt="2023-03-13T14:35:03.735" v="1075" actId="478"/>
          <ac:picMkLst>
            <pc:docMk/>
            <pc:sldMk cId="1223200249" sldId="310"/>
            <ac:picMk id="5" creationId="{408953DC-93D1-6818-DA1A-84BBACE2A2EB}"/>
          </ac:picMkLst>
        </pc:picChg>
        <pc:picChg chg="add del mod modCrop">
          <ac:chgData name="Varga Kinga Edina" userId="70f79362-1689-4710-90f8-3ef476fdf0b2" providerId="ADAL" clId="{E54B7B39-E2C1-4F73-A696-4EDA7F4A108E}" dt="2023-03-13T14:34:01.035" v="1058" actId="478"/>
          <ac:picMkLst>
            <pc:docMk/>
            <pc:sldMk cId="1223200249" sldId="310"/>
            <ac:picMk id="7" creationId="{04541785-A878-F9A2-3349-CF044A65A71B}"/>
          </ac:picMkLst>
        </pc:picChg>
        <pc:picChg chg="add del mod modCrop">
          <ac:chgData name="Varga Kinga Edina" userId="70f79362-1689-4710-90f8-3ef476fdf0b2" providerId="ADAL" clId="{E54B7B39-E2C1-4F73-A696-4EDA7F4A108E}" dt="2023-03-13T14:34:00.669" v="1057" actId="478"/>
          <ac:picMkLst>
            <pc:docMk/>
            <pc:sldMk cId="1223200249" sldId="310"/>
            <ac:picMk id="9" creationId="{6EFB2732-8BBA-EFCA-9840-A89684E7433B}"/>
          </ac:picMkLst>
        </pc:picChg>
        <pc:picChg chg="add del mod modCrop">
          <ac:chgData name="Varga Kinga Edina" userId="70f79362-1689-4710-90f8-3ef476fdf0b2" providerId="ADAL" clId="{E54B7B39-E2C1-4F73-A696-4EDA7F4A108E}" dt="2023-03-13T14:34:00.090" v="1056" actId="478"/>
          <ac:picMkLst>
            <pc:docMk/>
            <pc:sldMk cId="1223200249" sldId="310"/>
            <ac:picMk id="11" creationId="{C0D2C90F-8B34-C8FA-3544-A2FBF0A9F19C}"/>
          </ac:picMkLst>
        </pc:picChg>
        <pc:picChg chg="add del mod">
          <ac:chgData name="Varga Kinga Edina" userId="70f79362-1689-4710-90f8-3ef476fdf0b2" providerId="ADAL" clId="{E54B7B39-E2C1-4F73-A696-4EDA7F4A108E}" dt="2023-03-13T14:33:53.951" v="1055" actId="478"/>
          <ac:picMkLst>
            <pc:docMk/>
            <pc:sldMk cId="1223200249" sldId="310"/>
            <ac:picMk id="19" creationId="{6A0F9504-C9FD-9440-20F6-8F85E7A8B6FB}"/>
          </ac:picMkLst>
        </pc:picChg>
        <pc:picChg chg="add del mod modCrop">
          <ac:chgData name="Varga Kinga Edina" userId="70f79362-1689-4710-90f8-3ef476fdf0b2" providerId="ADAL" clId="{E54B7B39-E2C1-4F73-A696-4EDA7F4A108E}" dt="2023-03-13T14:34:50.227" v="1069" actId="478"/>
          <ac:picMkLst>
            <pc:docMk/>
            <pc:sldMk cId="1223200249" sldId="310"/>
            <ac:picMk id="23" creationId="{A3329508-499E-EDD2-D4D2-EA8898FA303A}"/>
          </ac:picMkLst>
        </pc:picChg>
        <pc:picChg chg="add del mod modCrop">
          <ac:chgData name="Varga Kinga Edina" userId="70f79362-1689-4710-90f8-3ef476fdf0b2" providerId="ADAL" clId="{E54B7B39-E2C1-4F73-A696-4EDA7F4A108E}" dt="2023-03-13T14:34:46.682" v="1068" actId="478"/>
          <ac:picMkLst>
            <pc:docMk/>
            <pc:sldMk cId="1223200249" sldId="310"/>
            <ac:picMk id="27" creationId="{2430B1BE-F1B7-972D-C3AF-A76A010FC1BB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31" creationId="{CDFC1B38-A9E7-1AB8-211B-62B7C1232135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35" creationId="{5D750071-DF1F-C485-C845-9A0F1F3D2EE3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37" creationId="{86DFAC94-EDF6-1FD0-B0E1-92F2F0D1A6FE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39" creationId="{52CC3405-1EAE-0D05-66AD-635C405B4D1F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41" creationId="{B49FCA8E-4067-F8AD-CDF9-04D490C5667F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43" creationId="{99476A16-09B9-DC2A-F6E4-C24347BF8E0C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45" creationId="{46BB56C9-9A14-0351-BA1A-83644C77F671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47" creationId="{2C29A947-5C60-FED6-CE14-69D11F9C575B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49" creationId="{2F5D4E82-96C0-1851-B673-C5335FC793C9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51" creationId="{1927C858-5B9E-530E-52B4-1A9E3283AE17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53" creationId="{A4B5C00E-A1F9-4B12-E951-18C17AE45B75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55" creationId="{ED659B97-DBEE-DE5E-4360-D281C8068D5B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57" creationId="{2E93385D-BCEF-8CE1-6C6A-EA0E64AF9E8E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59" creationId="{E04C8CA1-CB36-F401-58B3-E616928F43D9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61" creationId="{24A25BF5-C585-DD3D-4F0D-7AF59637C95D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63" creationId="{270A1A5D-050A-C833-DE4C-10AC4A9ABECB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65" creationId="{5308C361-364C-3FC6-9C49-CAD7AC34F6A7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67" creationId="{E3ED242A-7002-2679-6B09-4F7C0F9B9268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69" creationId="{11718FEA-3CFC-AD14-0EE4-12683D81CEF4}"/>
          </ac:picMkLst>
        </pc:picChg>
        <pc:picChg chg="add mod modCrop">
          <ac:chgData name="Varga Kinga Edina" userId="70f79362-1689-4710-90f8-3ef476fdf0b2" providerId="ADAL" clId="{E54B7B39-E2C1-4F73-A696-4EDA7F4A108E}" dt="2023-03-14T08:30:58.530" v="1261" actId="164"/>
          <ac:picMkLst>
            <pc:docMk/>
            <pc:sldMk cId="1223200249" sldId="310"/>
            <ac:picMk id="71" creationId="{AFD91FA9-BAAA-8D66-AAC2-DB591E2E7B51}"/>
          </ac:picMkLst>
        </pc:picChg>
      </pc:sldChg>
      <pc:sldChg chg="addSp delSp modSp add mod">
        <pc:chgData name="Varga Kinga Edina" userId="70f79362-1689-4710-90f8-3ef476fdf0b2" providerId="ADAL" clId="{E54B7B39-E2C1-4F73-A696-4EDA7F4A108E}" dt="2023-04-13T11:32:07.683" v="2425" actId="20577"/>
        <pc:sldMkLst>
          <pc:docMk/>
          <pc:sldMk cId="1782387281" sldId="311"/>
        </pc:sldMkLst>
        <pc:grpChg chg="add mod">
          <ac:chgData name="Varga Kinga Edina" userId="70f79362-1689-4710-90f8-3ef476fdf0b2" providerId="ADAL" clId="{E54B7B39-E2C1-4F73-A696-4EDA7F4A108E}" dt="2023-03-21T10:35:36.678" v="1664" actId="1076"/>
          <ac:grpSpMkLst>
            <pc:docMk/>
            <pc:sldMk cId="1782387281" sldId="311"/>
            <ac:grpSpMk id="70" creationId="{1B570C9B-1232-F5D5-9D82-1A0761AE44B7}"/>
          </ac:grpSpMkLst>
        </pc:grpChg>
        <pc:grpChg chg="del">
          <ac:chgData name="Varga Kinga Edina" userId="70f79362-1689-4710-90f8-3ef476fdf0b2" providerId="ADAL" clId="{E54B7B39-E2C1-4F73-A696-4EDA7F4A108E}" dt="2023-03-21T09:53:08.655" v="1274" actId="478"/>
          <ac:grpSpMkLst>
            <pc:docMk/>
            <pc:sldMk cId="1782387281" sldId="311"/>
            <ac:grpSpMk id="72" creationId="{45484852-01E0-7CA8-805E-82CEF6516FBB}"/>
          </ac:grpSpMkLst>
        </pc:grpChg>
        <pc:graphicFrameChg chg="mod modGraphic">
          <ac:chgData name="Varga Kinga Edina" userId="70f79362-1689-4710-90f8-3ef476fdf0b2" providerId="ADAL" clId="{E54B7B39-E2C1-4F73-A696-4EDA7F4A108E}" dt="2023-04-13T11:32:07.683" v="2425" actId="20577"/>
          <ac:graphicFrameMkLst>
            <pc:docMk/>
            <pc:sldMk cId="1782387281" sldId="311"/>
            <ac:graphicFrameMk id="12" creationId="{35A42593-0C7F-8C08-0F7E-2F9FB01F1904}"/>
          </ac:graphicFrameMkLst>
        </pc:graphicFrame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3" creationId="{01D21891-564F-D4F8-C99B-14AF7704B418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5" creationId="{12A74CA4-F0BB-F2DE-8BDA-CBFA4031AA67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7" creationId="{F1C9474F-617F-77CF-80A4-F84E9B4D0620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9" creationId="{BA84C534-AA01-A516-424B-E94769FF0333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11" creationId="{A1CC4052-25C0-35A8-56F4-4A82B6FEAF06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14" creationId="{E141D61D-4D3D-83E3-D6CD-9478F20E2345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16" creationId="{2C0F0DA5-3C37-A437-73C1-E75D3DE5B318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18" creationId="{5D16BD99-0C3A-2155-BEF6-7240C46F15E8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20" creationId="{64D8DCA4-039F-EAE1-F94E-DE19CC7955F4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22" creationId="{3EF32CAE-9AB7-B5C2-8F05-B117DD945D80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24" creationId="{7A467793-D234-7691-0266-6762CAC62207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26" creationId="{7D8706B7-2383-C4E5-6E9B-6B11AA621B36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28" creationId="{0A6DD8F7-9124-CDE4-42EE-E59BB08C3280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30" creationId="{65C0CA57-E226-31C4-FAB6-EE4F10A71817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33" creationId="{089A5220-FA5B-F4CC-7756-6FDA289E37BA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36" creationId="{6C806C2D-674B-FA00-6B56-1135D06EEB3C}"/>
          </ac:picMkLst>
        </pc:picChg>
        <pc:picChg chg="add del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40" creationId="{03B1A769-3106-6536-00BA-B85D23B40DE5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44" creationId="{6FDB4F0D-4A6B-3093-8876-C1E963039C83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48" creationId="{919ACF6F-B85B-4451-425A-763922585FFA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52" creationId="{8C6CDC34-2E93-E9BB-AC6D-32B6DD3ACA6C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56" creationId="{4362258A-72A1-04E5-32C3-197235C2C4AE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60" creationId="{A7E32068-497F-5764-D848-DD088602C0A6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64" creationId="{4086AB13-CF01-FECE-4CAA-684CE2F9250A}"/>
          </ac:picMkLst>
        </pc:picChg>
        <pc:picChg chg="add mod modCrop">
          <ac:chgData name="Varga Kinga Edina" userId="70f79362-1689-4710-90f8-3ef476fdf0b2" providerId="ADAL" clId="{E54B7B39-E2C1-4F73-A696-4EDA7F4A108E}" dt="2023-03-21T10:35:07.531" v="1661" actId="164"/>
          <ac:picMkLst>
            <pc:docMk/>
            <pc:sldMk cId="1782387281" sldId="311"/>
            <ac:picMk id="68" creationId="{9D49AE91-05AB-B234-DF33-485DC9937E89}"/>
          </ac:picMkLst>
        </pc:picChg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4222070158" sldId="311"/>
        </pc:sldMkLst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1130474822" sldId="312"/>
        </pc:sldMkLst>
      </pc:sldChg>
      <pc:sldChg chg="addSp delSp modSp add mod ord">
        <pc:chgData name="Varga Kinga Edina" userId="70f79362-1689-4710-90f8-3ef476fdf0b2" providerId="ADAL" clId="{E54B7B39-E2C1-4F73-A696-4EDA7F4A108E}" dt="2023-04-03T13:00:26.825" v="1870"/>
        <pc:sldMkLst>
          <pc:docMk/>
          <pc:sldMk cId="2693601676" sldId="312"/>
        </pc:sldMkLst>
        <pc:grpChg chg="add mod">
          <ac:chgData name="Varga Kinga Edina" userId="70f79362-1689-4710-90f8-3ef476fdf0b2" providerId="ADAL" clId="{E54B7B39-E2C1-4F73-A696-4EDA7F4A108E}" dt="2023-04-03T13:00:22.298" v="1869" actId="1076"/>
          <ac:grpSpMkLst>
            <pc:docMk/>
            <pc:sldMk cId="2693601676" sldId="312"/>
            <ac:grpSpMk id="54" creationId="{B1EDA939-F013-07CA-B3FC-F5C6B006E84F}"/>
          </ac:grpSpMkLst>
        </pc:grpChg>
        <pc:grpChg chg="del">
          <ac:chgData name="Varga Kinga Edina" userId="70f79362-1689-4710-90f8-3ef476fdf0b2" providerId="ADAL" clId="{E54B7B39-E2C1-4F73-A696-4EDA7F4A108E}" dt="2023-04-03T12:46:37.094" v="1679" actId="478"/>
          <ac:grpSpMkLst>
            <pc:docMk/>
            <pc:sldMk cId="2693601676" sldId="312"/>
            <ac:grpSpMk id="72" creationId="{45484852-01E0-7CA8-805E-82CEF6516FBB}"/>
          </ac:grpSpMkLst>
        </pc:grpChg>
        <pc:graphicFrameChg chg="mod modGraphic">
          <ac:chgData name="Varga Kinga Edina" userId="70f79362-1689-4710-90f8-3ef476fdf0b2" providerId="ADAL" clId="{E54B7B39-E2C1-4F73-A696-4EDA7F4A108E}" dt="2023-04-03T13:00:26.825" v="1870"/>
          <ac:graphicFrameMkLst>
            <pc:docMk/>
            <pc:sldMk cId="2693601676" sldId="312"/>
            <ac:graphicFrameMk id="12" creationId="{35A42593-0C7F-8C08-0F7E-2F9FB01F1904}"/>
          </ac:graphicFrameMkLst>
        </pc:graphicFrame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3" creationId="{92817BE1-A8E1-5BFB-D2C3-D0973EF038B0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5" creationId="{F437700D-67EB-FB0F-DE99-9E4E8867AF95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7" creationId="{D773D129-5D61-B5C9-A543-E09349217A98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9" creationId="{BB2828A1-64D8-ED72-CB88-2B402E27A08C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11" creationId="{10BFE3F6-900F-523E-50FA-E8BB93E82F3C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14" creationId="{787E00FE-9164-A8EF-909C-417C0FB2C417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16" creationId="{4C3F87FA-EE71-2359-C46A-9B9FBF4BB345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18" creationId="{95B72E54-30ED-369C-C8EF-B9E85BB06A90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20" creationId="{027964F2-25DC-EC78-5C58-59829972474A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22" creationId="{2B532D5D-77DC-8E7C-C397-91457B69D886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24" creationId="{824ABCC1-07DD-E9A4-57DE-2B75815F520E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26" creationId="{F39E68CB-1546-73E8-BF39-B436F8ED48E1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28" creationId="{7359895D-70F2-B61D-5D95-DA2A7BF58662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30" creationId="{7B1CDA9C-8D8E-D1AD-5EE1-E86CE40DBF3B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33" creationId="{A699D6F2-7FE8-FAE9-8D29-153F7CC849F8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36" creationId="{D7CF67B7-E065-A4BB-15DB-C4FC281EBD5D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40" creationId="{F453E137-50A8-6436-2537-207D19E15A33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44" creationId="{0C6205BD-26AD-5FFB-4B3C-432365CD0067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48" creationId="{04651D75-8DE2-F1CE-2A97-D25DA1BD6A10}"/>
          </ac:picMkLst>
        </pc:picChg>
        <pc:picChg chg="add mod modCrop">
          <ac:chgData name="Varga Kinga Edina" userId="70f79362-1689-4710-90f8-3ef476fdf0b2" providerId="ADAL" clId="{E54B7B39-E2C1-4F73-A696-4EDA7F4A108E}" dt="2023-04-03T13:00:03.858" v="1866" actId="164"/>
          <ac:picMkLst>
            <pc:docMk/>
            <pc:sldMk cId="2693601676" sldId="312"/>
            <ac:picMk id="52" creationId="{B6DF49D2-6CD9-F6F2-8694-FECEC4C408D6}"/>
          </ac:picMkLst>
        </pc:picChg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1835868461" sldId="313"/>
        </pc:sldMkLst>
      </pc:sldChg>
      <pc:sldChg chg="addSp delSp modSp add mod">
        <pc:chgData name="Varga Kinga Edina" userId="70f79362-1689-4710-90f8-3ef476fdf0b2" providerId="ADAL" clId="{E54B7B39-E2C1-4F73-A696-4EDA7F4A108E}" dt="2023-04-13T10:09:10.058" v="2423"/>
        <pc:sldMkLst>
          <pc:docMk/>
          <pc:sldMk cId="4164434808" sldId="313"/>
        </pc:sldMkLst>
        <pc:grpChg chg="add mod">
          <ac:chgData name="Varga Kinga Edina" userId="70f79362-1689-4710-90f8-3ef476fdf0b2" providerId="ADAL" clId="{E54B7B39-E2C1-4F73-A696-4EDA7F4A108E}" dt="2023-04-13T10:09:04.367" v="2422" actId="1076"/>
          <ac:grpSpMkLst>
            <pc:docMk/>
            <pc:sldMk cId="4164434808" sldId="313"/>
            <ac:grpSpMk id="43" creationId="{998FAF4A-96EE-5DD2-B2AA-3AFAD7BF9B35}"/>
          </ac:grpSpMkLst>
        </pc:grpChg>
        <pc:grpChg chg="del">
          <ac:chgData name="Varga Kinga Edina" userId="70f79362-1689-4710-90f8-3ef476fdf0b2" providerId="ADAL" clId="{E54B7B39-E2C1-4F73-A696-4EDA7F4A108E}" dt="2023-04-13T08:59:41.996" v="1988" actId="478"/>
          <ac:grpSpMkLst>
            <pc:docMk/>
            <pc:sldMk cId="4164434808" sldId="313"/>
            <ac:grpSpMk id="54" creationId="{B1EDA939-F013-07CA-B3FC-F5C6B006E84F}"/>
          </ac:grpSpMkLst>
        </pc:grpChg>
        <pc:graphicFrameChg chg="mod modGraphic">
          <ac:chgData name="Varga Kinga Edina" userId="70f79362-1689-4710-90f8-3ef476fdf0b2" providerId="ADAL" clId="{E54B7B39-E2C1-4F73-A696-4EDA7F4A108E}" dt="2023-04-13T10:09:10.058" v="2423"/>
          <ac:graphicFrameMkLst>
            <pc:docMk/>
            <pc:sldMk cId="4164434808" sldId="313"/>
            <ac:graphicFrameMk id="12" creationId="{35A42593-0C7F-8C08-0F7E-2F9FB01F1904}"/>
          </ac:graphicFrameMkLst>
        </pc:graphicFrameChg>
        <pc:picChg chg="add mod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2" creationId="{0D2864B6-8305-7B13-42B2-980EF1AD1859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6" creationId="{129FB7BB-CCA0-796C-0D75-FE5B1AF07491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10" creationId="{3CE60A09-10FC-BD7F-B435-02DC2A883499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15" creationId="{A54A2CF7-D781-B4A5-2757-079327821628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19" creationId="{A8182B7B-2FA8-AD28-550C-A1BDB34B9769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23" creationId="{AA310EFB-5754-14E8-106E-C0421CD016B5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27" creationId="{BD9002E4-AAEA-722D-83EB-CAB16BBB952E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31" creationId="{E07A58C8-4B66-FBD9-4C1A-2628665E9571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34" creationId="{0E1153CC-2C2E-0F0C-10F7-EA4F097A826F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37" creationId="{1222E2B1-4725-ED98-DF17-A446E82035D0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39" creationId="{D210F35D-9C42-9F0F-7365-988BFD241C67}"/>
          </ac:picMkLst>
        </pc:picChg>
        <pc:picChg chg="add mod modCrop">
          <ac:chgData name="Varga Kinga Edina" userId="70f79362-1689-4710-90f8-3ef476fdf0b2" providerId="ADAL" clId="{E54B7B39-E2C1-4F73-A696-4EDA7F4A108E}" dt="2023-04-13T10:08:34.655" v="2419" actId="164"/>
          <ac:picMkLst>
            <pc:docMk/>
            <pc:sldMk cId="4164434808" sldId="313"/>
            <ac:picMk id="42" creationId="{5011E117-8485-F6C0-2394-B18FA71C2C7B}"/>
          </ac:picMkLst>
        </pc:picChg>
      </pc:sldChg>
      <pc:sldChg chg="del">
        <pc:chgData name="Varga Kinga Edina" userId="70f79362-1689-4710-90f8-3ef476fdf0b2" providerId="ADAL" clId="{E54B7B39-E2C1-4F73-A696-4EDA7F4A108E}" dt="2023-03-09T13:09:49.666" v="0" actId="47"/>
        <pc:sldMkLst>
          <pc:docMk/>
          <pc:sldMk cId="350646724" sldId="314"/>
        </pc:sldMkLst>
      </pc:sldChg>
      <pc:sldChg chg="addSp modSp add mod ord">
        <pc:chgData name="Varga Kinga Edina" userId="70f79362-1689-4710-90f8-3ef476fdf0b2" providerId="ADAL" clId="{E54B7B39-E2C1-4F73-A696-4EDA7F4A108E}" dt="2023-04-17T14:59:07.793" v="2427" actId="20577"/>
        <pc:sldMkLst>
          <pc:docMk/>
          <pc:sldMk cId="2233749773" sldId="314"/>
        </pc:sldMkLst>
        <pc:grpChg chg="add mod">
          <ac:chgData name="Varga Kinga Edina" userId="70f79362-1689-4710-90f8-3ef476fdf0b2" providerId="ADAL" clId="{E54B7B39-E2C1-4F73-A696-4EDA7F4A108E}" dt="2023-04-13T09:54:54.081" v="2329" actId="1076"/>
          <ac:grpSpMkLst>
            <pc:docMk/>
            <pc:sldMk cId="2233749773" sldId="314"/>
            <ac:grpSpMk id="19" creationId="{AA93FE91-6BA0-486C-467B-81C62C4217D4}"/>
          </ac:grpSpMkLst>
        </pc:grpChg>
        <pc:graphicFrameChg chg="mod modGraphic">
          <ac:chgData name="Varga Kinga Edina" userId="70f79362-1689-4710-90f8-3ef476fdf0b2" providerId="ADAL" clId="{E54B7B39-E2C1-4F73-A696-4EDA7F4A108E}" dt="2023-04-17T14:59:07.793" v="2427" actId="20577"/>
          <ac:graphicFrameMkLst>
            <pc:docMk/>
            <pc:sldMk cId="2233749773" sldId="314"/>
            <ac:graphicFrameMk id="12" creationId="{35A42593-0C7F-8C08-0F7E-2F9FB01F1904}"/>
          </ac:graphicFrameMkLst>
        </pc:graphicFrame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3" creationId="{143B9179-6E5C-8DBC-E3D6-59D056B26A64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5" creationId="{9926E5C4-F7C3-F70F-10CB-E093EC8F3F30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7" creationId="{B1AF722F-FCDB-63CC-9907-7AA7B5920B93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9" creationId="{4BBEE9D1-8DCE-B4F8-C09E-C2D433320300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11" creationId="{6E41665A-92E5-E5D4-8263-00C226535509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14" creationId="{24963F61-2EDC-1C81-CB0D-B252EFEF5B07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16" creationId="{03D2D07B-FB08-6CF5-7CB4-74A470EB7D32}"/>
          </ac:picMkLst>
        </pc:picChg>
        <pc:picChg chg="add mod modCrop">
          <ac:chgData name="Varga Kinga Edina" userId="70f79362-1689-4710-90f8-3ef476fdf0b2" providerId="ADAL" clId="{E54B7B39-E2C1-4F73-A696-4EDA7F4A108E}" dt="2023-04-13T09:54:45.414" v="2328" actId="164"/>
          <ac:picMkLst>
            <pc:docMk/>
            <pc:sldMk cId="2233749773" sldId="314"/>
            <ac:picMk id="18" creationId="{6F68B803-E806-134F-0B9F-3DEA17A4D1B0}"/>
          </ac:picMkLst>
        </pc:picChg>
      </pc:sldChg>
      <pc:sldChg chg="addSp delSp modSp add mod ord">
        <pc:chgData name="Varga Kinga Edina" userId="70f79362-1689-4710-90f8-3ef476fdf0b2" providerId="ADAL" clId="{E54B7B39-E2C1-4F73-A696-4EDA7F4A108E}" dt="2023-04-17T15:21:58.069" v="2750"/>
        <pc:sldMkLst>
          <pc:docMk/>
          <pc:sldMk cId="3562875155" sldId="315"/>
        </pc:sldMkLst>
        <pc:grpChg chg="del">
          <ac:chgData name="Varga Kinga Edina" userId="70f79362-1689-4710-90f8-3ef476fdf0b2" providerId="ADAL" clId="{E54B7B39-E2C1-4F73-A696-4EDA7F4A108E}" dt="2023-04-17T15:00:28.557" v="2437" actId="478"/>
          <ac:grpSpMkLst>
            <pc:docMk/>
            <pc:sldMk cId="3562875155" sldId="315"/>
            <ac:grpSpMk id="64" creationId="{B344D44A-12FF-09DC-884F-37D34FDB2068}"/>
          </ac:grpSpMkLst>
        </pc:grpChg>
        <pc:grpChg chg="add mod">
          <ac:chgData name="Varga Kinga Edina" userId="70f79362-1689-4710-90f8-3ef476fdf0b2" providerId="ADAL" clId="{E54B7B39-E2C1-4F73-A696-4EDA7F4A108E}" dt="2023-04-17T15:21:50.877" v="2749" actId="1076"/>
          <ac:grpSpMkLst>
            <pc:docMk/>
            <pc:sldMk cId="3562875155" sldId="315"/>
            <ac:grpSpMk id="66" creationId="{39642B28-F8EE-70F6-EA83-D50E12807DB9}"/>
          </ac:grpSpMkLst>
        </pc:grpChg>
        <pc:graphicFrameChg chg="mod modGraphic">
          <ac:chgData name="Varga Kinga Edina" userId="70f79362-1689-4710-90f8-3ef476fdf0b2" providerId="ADAL" clId="{E54B7B39-E2C1-4F73-A696-4EDA7F4A108E}" dt="2023-04-17T15:21:58.069" v="2750"/>
          <ac:graphicFrameMkLst>
            <pc:docMk/>
            <pc:sldMk cId="3562875155" sldId="315"/>
            <ac:graphicFrameMk id="12" creationId="{35A42593-0C7F-8C08-0F7E-2F9FB01F1904}"/>
          </ac:graphicFrameMkLst>
        </pc:graphicFrameChg>
        <pc:picChg chg="add mod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3" creationId="{DADBAAD2-899D-3177-377F-CF8CF695ED61}"/>
          </ac:picMkLst>
        </pc:picChg>
        <pc:picChg chg="add mod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5" creationId="{A54D4286-B05E-8F15-C93A-9AB6D025C7F5}"/>
          </ac:picMkLst>
        </pc:picChg>
        <pc:picChg chg="add mod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7" creationId="{05D77663-CDB5-C9FF-0AB8-C3313215AE94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11" creationId="{E981E042-98F4-3EE9-E3F0-B429C499D231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14" creationId="{87DED47C-3CCC-7577-1331-3C8E2031FD1E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17" creationId="{03F6EB99-4686-55A6-6E7C-A195660DEEF1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20" creationId="{FB2F87DC-9961-1841-A515-5205DA04F667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22" creationId="{9417B0E7-B21A-E406-48AC-6C0971223136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25" creationId="{CC0BC16A-8112-1889-3660-FB276D6DB7AA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27" creationId="{E7AD4E94-5CF5-3EE0-DACB-48FA8CACD7E4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31" creationId="{02646617-D647-8D2D-1B03-63BDB97D6AB6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35" creationId="{FD59320B-4CD9-4DC8-83F0-D0B3CBAB07E8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37" creationId="{CF23E8F3-44FE-9156-F805-B93C5EDB2A07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41" creationId="{2849931D-08D3-959B-4C7E-70C790C4390B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45" creationId="{486764A7-38D1-AFD6-0A44-DC752A069C17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49" creationId="{A286CEE7-246C-2D2F-2D66-3399F3C0DC1B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53" creationId="{94768E7D-1E9C-B9A5-A27D-08BD06DE13C0}"/>
          </ac:picMkLst>
        </pc:picChg>
        <pc:picChg chg="add mod modCrop">
          <ac:chgData name="Varga Kinga Edina" userId="70f79362-1689-4710-90f8-3ef476fdf0b2" providerId="ADAL" clId="{E54B7B39-E2C1-4F73-A696-4EDA7F4A108E}" dt="2023-04-17T15:21:22.261" v="2746" actId="164"/>
          <ac:picMkLst>
            <pc:docMk/>
            <pc:sldMk cId="3562875155" sldId="315"/>
            <ac:picMk id="65" creationId="{137F2937-D84D-4C1A-D6EA-968ED014A158}"/>
          </ac:picMkLst>
        </pc:picChg>
      </pc:sldChg>
      <pc:sldChg chg="addSp modSp add mod">
        <pc:chgData name="Varga Kinga Edina" userId="70f79362-1689-4710-90f8-3ef476fdf0b2" providerId="ADAL" clId="{E54B7B39-E2C1-4F73-A696-4EDA7F4A108E}" dt="2023-04-17T15:10:14.565" v="2580"/>
        <pc:sldMkLst>
          <pc:docMk/>
          <pc:sldMk cId="1131867421" sldId="316"/>
        </pc:sldMkLst>
        <pc:grpChg chg="add mod">
          <ac:chgData name="Varga Kinga Edina" userId="70f79362-1689-4710-90f8-3ef476fdf0b2" providerId="ADAL" clId="{E54B7B39-E2C1-4F73-A696-4EDA7F4A108E}" dt="2023-04-17T15:10:10.741" v="2579" actId="1076"/>
          <ac:grpSpMkLst>
            <pc:docMk/>
            <pc:sldMk cId="1131867421" sldId="316"/>
            <ac:grpSpMk id="21" creationId="{B18D4D0C-F864-9169-7A0D-799E0968FE70}"/>
          </ac:grpSpMkLst>
        </pc:grpChg>
        <pc:graphicFrameChg chg="mod modGraphic">
          <ac:chgData name="Varga Kinga Edina" userId="70f79362-1689-4710-90f8-3ef476fdf0b2" providerId="ADAL" clId="{E54B7B39-E2C1-4F73-A696-4EDA7F4A108E}" dt="2023-04-17T15:10:14.565" v="2580"/>
          <ac:graphicFrameMkLst>
            <pc:docMk/>
            <pc:sldMk cId="1131867421" sldId="316"/>
            <ac:graphicFrameMk id="12" creationId="{35A42593-0C7F-8C08-0F7E-2F9FB01F1904}"/>
          </ac:graphicFrameMkLst>
        </pc:graphicFrame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3" creationId="{421C3DD5-08DE-83F1-A728-83D41DC16D98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5" creationId="{9114163C-E16C-954D-D794-08FF8EF43874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7" creationId="{FC4B7139-00DE-8B08-214E-AF52E7213329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9" creationId="{3CD37D3F-F85C-F594-4ABD-C517A9E54371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11" creationId="{621D5A76-D26D-6E6D-7DA9-312CD1FD2A7D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14" creationId="{01500047-EB3C-9A4C-BA0B-9EE3655A4B52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16" creationId="{9E5D4C75-843C-7BCD-1147-D035ED9B2A6A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18" creationId="{A6E058D8-32C4-2033-2095-006A62DB2DBC}"/>
          </ac:picMkLst>
        </pc:picChg>
        <pc:picChg chg="add mod modCrop">
          <ac:chgData name="Varga Kinga Edina" userId="70f79362-1689-4710-90f8-3ef476fdf0b2" providerId="ADAL" clId="{E54B7B39-E2C1-4F73-A696-4EDA7F4A108E}" dt="2023-04-17T15:09:54.847" v="2576" actId="164"/>
          <ac:picMkLst>
            <pc:docMk/>
            <pc:sldMk cId="1131867421" sldId="316"/>
            <ac:picMk id="20" creationId="{E35DAB2B-6C3A-A172-8909-C90B7A4AE370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%20Emri%20Tam&#225;s\Desktop\Fig%201Ahoz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%20Emri%20Tam&#225;s\Desktop\Fig%201Ahoz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SB és egyéb'!$G$3</c:f>
              <c:strCache>
                <c:ptCount val="1"/>
                <c:pt idx="0">
                  <c:v>x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E34-4516-BA8D-265BD22B199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E34-4516-BA8D-265BD22B199F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E34-4516-BA8D-265BD22B199F}"/>
              </c:ext>
            </c:extLst>
          </c:dPt>
          <c:errBars>
            <c:errBarType val="plus"/>
            <c:errValType val="cust"/>
            <c:noEndCap val="0"/>
            <c:plus>
              <c:numRef>
                <c:f>'MSB és egyéb'!$H$4:$H$9</c:f>
                <c:numCache>
                  <c:formatCode>General</c:formatCode>
                  <c:ptCount val="6"/>
                  <c:pt idx="0">
                    <c:v>1.1547005383792517</c:v>
                  </c:pt>
                  <c:pt idx="1">
                    <c:v>1.1547005383792517</c:v>
                  </c:pt>
                  <c:pt idx="2">
                    <c:v>2.0816659994661326</c:v>
                  </c:pt>
                  <c:pt idx="3">
                    <c:v>0.57735026918962584</c:v>
                  </c:pt>
                  <c:pt idx="4">
                    <c:v>2.5166114784235831</c:v>
                  </c:pt>
                  <c:pt idx="5">
                    <c:v>0.577350269189625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SB és egyéb'!$F$4:$F$9</c:f>
              <c:strCache>
                <c:ptCount val="6"/>
                <c:pt idx="0">
                  <c:v>untr</c:v>
                </c:pt>
                <c:pt idx="1">
                  <c:v>untr</c:v>
                </c:pt>
                <c:pt idx="2">
                  <c:v>CdCl2</c:v>
                </c:pt>
                <c:pt idx="3">
                  <c:v>CdCl2</c:v>
                </c:pt>
                <c:pt idx="4">
                  <c:v>DFP</c:v>
                </c:pt>
                <c:pt idx="5">
                  <c:v>DFP</c:v>
                </c:pt>
              </c:strCache>
            </c:strRef>
          </c:cat>
          <c:val>
            <c:numRef>
              <c:f>'MSB és egyéb'!$G$4:$G$9</c:f>
              <c:numCache>
                <c:formatCode>0.000</c:formatCode>
                <c:ptCount val="6"/>
                <c:pt idx="0">
                  <c:v>58.666666666666664</c:v>
                </c:pt>
                <c:pt idx="1">
                  <c:v>58.333333333333336</c:v>
                </c:pt>
                <c:pt idx="2">
                  <c:v>36.666666666666664</c:v>
                </c:pt>
                <c:pt idx="3">
                  <c:v>39.666666666666664</c:v>
                </c:pt>
                <c:pt idx="4">
                  <c:v>38.333333333333336</c:v>
                </c:pt>
                <c:pt idx="5">
                  <c:v>36.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E34-4516-BA8D-265BD22B19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9789520"/>
        <c:axId val="-129780816"/>
      </c:barChart>
      <c:catAx>
        <c:axId val="-129789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9780816"/>
        <c:crosses val="autoZero"/>
        <c:auto val="1"/>
        <c:lblAlgn val="ctr"/>
        <c:lblOffset val="100"/>
        <c:noMultiLvlLbl val="0"/>
      </c:catAx>
      <c:valAx>
        <c:axId val="-1297808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b="1"/>
                  <a:t>Colony</a:t>
                </a:r>
                <a:r>
                  <a:rPr lang="hu-HU" b="1" baseline="0"/>
                  <a:t> diameter (mm)</a:t>
                </a:r>
                <a:endParaRPr lang="en-US" b="1"/>
              </a:p>
            </c:rich>
          </c:tx>
          <c:layout>
            <c:manualLayout>
              <c:xMode val="edge"/>
              <c:yMode val="edge"/>
              <c:x val="1.5119047619047619E-2"/>
              <c:y val="0.262059722222222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978952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4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SB és egyéb'!$G$24</c:f>
              <c:strCache>
                <c:ptCount val="1"/>
                <c:pt idx="0">
                  <c:v>x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CC3-417A-804B-4EBAF5BE17B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CC3-417A-804B-4EBAF5BE17B6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CC3-417A-804B-4EBAF5BE17B6}"/>
              </c:ext>
            </c:extLst>
          </c:dPt>
          <c:errBars>
            <c:errBarType val="plus"/>
            <c:errValType val="cust"/>
            <c:noEndCap val="0"/>
            <c:plus>
              <c:numRef>
                <c:f>'MSB és egyéb'!$H$25:$H$30</c:f>
                <c:numCache>
                  <c:formatCode>General</c:formatCode>
                  <c:ptCount val="6"/>
                  <c:pt idx="0">
                    <c:v>1.5000000000000036</c:v>
                  </c:pt>
                  <c:pt idx="1">
                    <c:v>0.76376261582597338</c:v>
                  </c:pt>
                  <c:pt idx="2">
                    <c:v>0.57735026918962584</c:v>
                  </c:pt>
                  <c:pt idx="3">
                    <c:v>2.7838821814150108</c:v>
                  </c:pt>
                  <c:pt idx="4">
                    <c:v>1.7559422921421231</c:v>
                  </c:pt>
                  <c:pt idx="5">
                    <c:v>2.51661147842358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SB és egyéb'!$F$25:$F$30</c:f>
              <c:strCache>
                <c:ptCount val="6"/>
                <c:pt idx="0">
                  <c:v>untr</c:v>
                </c:pt>
                <c:pt idx="1">
                  <c:v>untr</c:v>
                </c:pt>
                <c:pt idx="2">
                  <c:v>tBOOH</c:v>
                </c:pt>
                <c:pt idx="3">
                  <c:v>tBOOH</c:v>
                </c:pt>
                <c:pt idx="4">
                  <c:v>H2O2</c:v>
                </c:pt>
                <c:pt idx="5">
                  <c:v>H2O2</c:v>
                </c:pt>
              </c:strCache>
            </c:strRef>
          </c:cat>
          <c:val>
            <c:numRef>
              <c:f>'MSB és egyéb'!$G$25:$G$30</c:f>
              <c:numCache>
                <c:formatCode>0.000</c:formatCode>
                <c:ptCount val="6"/>
                <c:pt idx="0">
                  <c:v>58.5</c:v>
                </c:pt>
                <c:pt idx="1">
                  <c:v>56.666666666666664</c:v>
                </c:pt>
                <c:pt idx="2">
                  <c:v>40.333333333333336</c:v>
                </c:pt>
                <c:pt idx="3">
                  <c:v>36.5</c:v>
                </c:pt>
                <c:pt idx="4">
                  <c:v>46.666666666666664</c:v>
                </c:pt>
                <c:pt idx="5">
                  <c:v>42.8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CC3-417A-804B-4EBAF5BE17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29788432"/>
        <c:axId val="-129788976"/>
      </c:barChart>
      <c:catAx>
        <c:axId val="-129788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9788976"/>
        <c:crosses val="autoZero"/>
        <c:auto val="1"/>
        <c:lblAlgn val="ctr"/>
        <c:lblOffset val="100"/>
        <c:noMultiLvlLbl val="0"/>
      </c:catAx>
      <c:valAx>
        <c:axId val="-1297889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sz="1400" b="1" i="0" baseline="0">
                    <a:effectLst/>
                  </a:rPr>
                  <a:t>Colony diameter (mm)</a:t>
                </a:r>
                <a:endParaRPr lang="en-US" sz="1400">
                  <a:effectLst/>
                </a:endParaRPr>
              </a:p>
            </c:rich>
          </c:tx>
          <c:layout>
            <c:manualLayout>
              <c:xMode val="edge"/>
              <c:yMode val="edge"/>
              <c:x val="2.0158730158730157E-2"/>
              <c:y val="0.265727314814814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9788432"/>
        <c:crosses val="autoZero"/>
        <c:crossBetween val="between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 sz="14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348</cdr:x>
      <cdr:y>0.91281</cdr:y>
    </cdr:from>
    <cdr:to>
      <cdr:x>0.33262</cdr:x>
      <cdr:y>0.93927</cdr:y>
    </cdr:to>
    <cdr:sp macro="" textlink="">
      <cdr:nvSpPr>
        <cdr:cNvPr id="2" name="Téglalap 1"/>
        <cdr:cNvSpPr/>
      </cdr:nvSpPr>
      <cdr:spPr>
        <a:xfrm xmlns:a="http://schemas.openxmlformats.org/drawingml/2006/main">
          <a:off x="1428750" y="3943350"/>
          <a:ext cx="247650" cy="1143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5563</cdr:x>
      <cdr:y>0.91376</cdr:y>
    </cdr:from>
    <cdr:to>
      <cdr:x>0.6107</cdr:x>
      <cdr:y>0.93644</cdr:y>
    </cdr:to>
    <cdr:sp macro="" textlink="">
      <cdr:nvSpPr>
        <cdr:cNvPr id="3" name="Téglalap 2"/>
        <cdr:cNvSpPr/>
      </cdr:nvSpPr>
      <cdr:spPr>
        <a:xfrm xmlns:a="http://schemas.openxmlformats.org/drawingml/2006/main">
          <a:off x="2800350" y="3947432"/>
          <a:ext cx="277586" cy="97972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0465</cdr:x>
      <cdr:y>0.91287</cdr:y>
    </cdr:from>
    <cdr:to>
      <cdr:x>0.87161</cdr:x>
      <cdr:y>0.9462</cdr:y>
    </cdr:to>
    <cdr:sp macro="" textlink="">
      <cdr:nvSpPr>
        <cdr:cNvPr id="4" name="Téglalap 3"/>
        <cdr:cNvSpPr/>
      </cdr:nvSpPr>
      <cdr:spPr>
        <a:xfrm xmlns:a="http://schemas.openxmlformats.org/drawingml/2006/main">
          <a:off x="4049469" y="3943584"/>
          <a:ext cx="336959" cy="1440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16812</cdr:x>
      <cdr:y>0.9075</cdr:y>
    </cdr:from>
    <cdr:to>
      <cdr:x>0.97413</cdr:x>
      <cdr:y>1</cdr:y>
    </cdr:to>
    <cdr:sp macro="" textlink="">
      <cdr:nvSpPr>
        <cdr:cNvPr id="5" name="Szövegdoboz 4"/>
        <cdr:cNvSpPr txBox="1"/>
      </cdr:nvSpPr>
      <cdr:spPr>
        <a:xfrm xmlns:a="http://schemas.openxmlformats.org/drawingml/2006/main">
          <a:off x="846097" y="3920415"/>
          <a:ext cx="4056258" cy="3995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       Untreated               </a:t>
          </a:r>
          <a:r>
            <a:rPr lang="hu-HU" sz="1200" baseline="0">
              <a:latin typeface="Times New Roman" panose="02020603050405020304" pitchFamily="18" charset="0"/>
              <a:cs typeface="Times New Roman" panose="02020603050405020304" pitchFamily="18" charset="0"/>
            </a:rPr>
            <a:t>  </a:t>
          </a:r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2 mM CdCl</a:t>
          </a:r>
          <a:r>
            <a:rPr lang="hu-HU" sz="1200" baseline="-2500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                 1 mM DFP</a:t>
          </a:r>
          <a:endParaRPr 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1702</cdr:x>
      <cdr:y>0.06104</cdr:y>
    </cdr:from>
    <cdr:to>
      <cdr:x>1</cdr:x>
      <cdr:y>0.27271</cdr:y>
    </cdr:to>
    <cdr:sp macro="" textlink="">
      <cdr:nvSpPr>
        <cdr:cNvPr id="6" name="Szövegdoboz 1"/>
        <cdr:cNvSpPr txBox="1"/>
      </cdr:nvSpPr>
      <cdr:spPr>
        <a:xfrm xmlns:a="http://schemas.openxmlformats.org/drawingml/2006/main">
          <a:off x="4088477" y="263712"/>
          <a:ext cx="915664" cy="914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Af293</a:t>
          </a:r>
        </a:p>
        <a:p xmlns:a="http://schemas.openxmlformats.org/drawingml/2006/main">
          <a:r>
            <a:rPr lang="hu-HU" sz="1200" i="1">
              <a:latin typeface="Symbol" panose="05050102010706020507" pitchFamily="18" charset="2"/>
              <a:cs typeface="Times New Roman" panose="02020603050405020304" pitchFamily="18" charset="0"/>
            </a:rPr>
            <a:t>D</a:t>
          </a:r>
          <a:r>
            <a:rPr lang="hu-HU" sz="1200" i="1">
              <a:latin typeface="Times New Roman" panose="02020603050405020304" pitchFamily="18" charset="0"/>
              <a:cs typeface="Times New Roman" panose="02020603050405020304" pitchFamily="18" charset="0"/>
            </a:rPr>
            <a:t>meaB</a:t>
          </a:r>
          <a:endParaRPr lang="en-US" sz="1200" i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0368</cdr:x>
      <cdr:y>0.07868</cdr:y>
    </cdr:from>
    <cdr:to>
      <cdr:x>0.82529</cdr:x>
      <cdr:y>0.10368</cdr:y>
    </cdr:to>
    <cdr:sp macro="" textlink="">
      <cdr:nvSpPr>
        <cdr:cNvPr id="7" name="Téglalap 6"/>
        <cdr:cNvSpPr/>
      </cdr:nvSpPr>
      <cdr:spPr>
        <a:xfrm xmlns:a="http://schemas.openxmlformats.org/drawingml/2006/main">
          <a:off x="4021707" y="339917"/>
          <a:ext cx="108155" cy="10800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1">
            <a:lumMod val="75000"/>
          </a:schemeClr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0431</cdr:x>
      <cdr:y>0.12351</cdr:y>
    </cdr:from>
    <cdr:to>
      <cdr:x>0.82592</cdr:x>
      <cdr:y>0.14851</cdr:y>
    </cdr:to>
    <cdr:sp macro="" textlink="">
      <cdr:nvSpPr>
        <cdr:cNvPr id="8" name="Téglalap 7"/>
        <cdr:cNvSpPr/>
      </cdr:nvSpPr>
      <cdr:spPr>
        <a:xfrm xmlns:a="http://schemas.openxmlformats.org/drawingml/2006/main">
          <a:off x="4024886" y="533583"/>
          <a:ext cx="108156" cy="10800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>
            <a:lumMod val="75000"/>
          </a:schemeClr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7354</cdr:x>
      <cdr:y>0.91309</cdr:y>
    </cdr:from>
    <cdr:to>
      <cdr:x>0.34116</cdr:x>
      <cdr:y>0.93789</cdr:y>
    </cdr:to>
    <cdr:sp macro="" textlink="">
      <cdr:nvSpPr>
        <cdr:cNvPr id="3" name="Téglalap 2"/>
        <cdr:cNvSpPr/>
      </cdr:nvSpPr>
      <cdr:spPr>
        <a:xfrm xmlns:a="http://schemas.openxmlformats.org/drawingml/2006/main">
          <a:off x="1372791" y="3944541"/>
          <a:ext cx="339329" cy="107156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3859</cdr:x>
      <cdr:y>0.91305</cdr:y>
    </cdr:from>
    <cdr:to>
      <cdr:x>0.60502</cdr:x>
      <cdr:y>0.97113</cdr:y>
    </cdr:to>
    <cdr:sp macro="" textlink="">
      <cdr:nvSpPr>
        <cdr:cNvPr id="4" name="Téglalap 3"/>
        <cdr:cNvSpPr/>
      </cdr:nvSpPr>
      <cdr:spPr>
        <a:xfrm xmlns:a="http://schemas.openxmlformats.org/drawingml/2006/main">
          <a:off x="2709975" y="3944397"/>
          <a:ext cx="334243" cy="250902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1451</cdr:x>
      <cdr:y>0.91305</cdr:y>
    </cdr:from>
    <cdr:to>
      <cdr:x>0.88284</cdr:x>
      <cdr:y>0.93672</cdr:y>
    </cdr:to>
    <cdr:sp macro="" textlink="">
      <cdr:nvSpPr>
        <cdr:cNvPr id="5" name="Téglalap 4"/>
        <cdr:cNvSpPr/>
      </cdr:nvSpPr>
      <cdr:spPr>
        <a:xfrm xmlns:a="http://schemas.openxmlformats.org/drawingml/2006/main">
          <a:off x="4098306" y="3944396"/>
          <a:ext cx="343829" cy="102219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22064</cdr:x>
      <cdr:y>0.91629</cdr:y>
    </cdr:from>
    <cdr:to>
      <cdr:x>0.97334</cdr:x>
      <cdr:y>0.99116</cdr:y>
    </cdr:to>
    <cdr:sp macro="" textlink="">
      <cdr:nvSpPr>
        <cdr:cNvPr id="6" name="Szövegdoboz 1"/>
        <cdr:cNvSpPr txBox="1"/>
      </cdr:nvSpPr>
      <cdr:spPr>
        <a:xfrm xmlns:a="http://schemas.openxmlformats.org/drawingml/2006/main">
          <a:off x="1110165" y="3958374"/>
          <a:ext cx="3787311" cy="3234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Untreated</a:t>
          </a:r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                8 </a:t>
          </a:r>
          <a:r>
            <a:rPr lang="hu-HU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M</a:t>
          </a:r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hu-HU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tBOOH</a:t>
          </a:r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             </a:t>
          </a:r>
          <a:r>
            <a:rPr lang="hu-HU" sz="12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0.5 </a:t>
          </a:r>
          <a:r>
            <a:rPr lang="hu-HU" sz="1200" dirty="0" err="1">
              <a:latin typeface="Times New Roman" panose="02020603050405020304" pitchFamily="18" charset="0"/>
              <a:cs typeface="Times New Roman" panose="02020603050405020304" pitchFamily="18" charset="0"/>
            </a:rPr>
            <a:t>mM</a:t>
          </a:r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 H</a:t>
          </a:r>
          <a:r>
            <a:rPr lang="hu-HU" sz="1100" baseline="-25000" dirty="0">
              <a:effectLst/>
              <a:latin typeface="+mn-lt"/>
              <a:ea typeface="+mn-ea"/>
              <a:cs typeface="+mn-cs"/>
            </a:rPr>
            <a:t>2</a:t>
          </a:r>
          <a:r>
            <a:rPr lang="hu-HU" sz="1200" dirty="0">
              <a:latin typeface="Times New Roman" panose="02020603050405020304" pitchFamily="18" charset="0"/>
              <a:cs typeface="Times New Roman" panose="02020603050405020304" pitchFamily="18" charset="0"/>
            </a:rPr>
            <a:t>O</a:t>
          </a:r>
          <a:r>
            <a:rPr lang="hu-HU" sz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2</a:t>
          </a:r>
          <a:endParaRPr lang="en-US" sz="1200" baseline="-25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1685</cdr:x>
      <cdr:y>0.0818</cdr:y>
    </cdr:from>
    <cdr:to>
      <cdr:x>1</cdr:x>
      <cdr:y>0.29347</cdr:y>
    </cdr:to>
    <cdr:sp macro="" textlink="">
      <cdr:nvSpPr>
        <cdr:cNvPr id="7" name="Szövegdoboz 1"/>
        <cdr:cNvSpPr txBox="1"/>
      </cdr:nvSpPr>
      <cdr:spPr>
        <a:xfrm xmlns:a="http://schemas.openxmlformats.org/drawingml/2006/main">
          <a:off x="4083995" y="353359"/>
          <a:ext cx="915664" cy="914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Af293</a:t>
          </a:r>
        </a:p>
        <a:p xmlns:a="http://schemas.openxmlformats.org/drawingml/2006/main">
          <a:r>
            <a:rPr lang="hu-HU" sz="1200" i="1">
              <a:latin typeface="Symbol" panose="05050102010706020507" pitchFamily="18" charset="2"/>
              <a:cs typeface="Times New Roman" panose="02020603050405020304" pitchFamily="18" charset="0"/>
            </a:rPr>
            <a:t>D</a:t>
          </a:r>
          <a:r>
            <a:rPr lang="hu-HU" sz="1200" i="1">
              <a:latin typeface="Times New Roman" panose="02020603050405020304" pitchFamily="18" charset="0"/>
              <a:cs typeface="Times New Roman" panose="02020603050405020304" pitchFamily="18" charset="0"/>
            </a:rPr>
            <a:t>meaB</a:t>
          </a:r>
          <a:endParaRPr lang="en-US" sz="1200" i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035</cdr:x>
      <cdr:y>0.09944</cdr:y>
    </cdr:from>
    <cdr:to>
      <cdr:x>0.82513</cdr:x>
      <cdr:y>0.12444</cdr:y>
    </cdr:to>
    <cdr:sp macro="" textlink="">
      <cdr:nvSpPr>
        <cdr:cNvPr id="8" name="Téglalap 7"/>
        <cdr:cNvSpPr/>
      </cdr:nvSpPr>
      <cdr:spPr>
        <a:xfrm xmlns:a="http://schemas.openxmlformats.org/drawingml/2006/main">
          <a:off x="4017225" y="429564"/>
          <a:ext cx="108155" cy="10800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1">
            <a:lumMod val="75000"/>
          </a:schemeClr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80414</cdr:x>
      <cdr:y>0.14427</cdr:y>
    </cdr:from>
    <cdr:to>
      <cdr:x>0.82577</cdr:x>
      <cdr:y>0.16927</cdr:y>
    </cdr:to>
    <cdr:sp macro="" textlink="">
      <cdr:nvSpPr>
        <cdr:cNvPr id="9" name="Téglalap 8"/>
        <cdr:cNvSpPr/>
      </cdr:nvSpPr>
      <cdr:spPr>
        <a:xfrm xmlns:a="http://schemas.openxmlformats.org/drawingml/2006/main">
          <a:off x="4020404" y="623230"/>
          <a:ext cx="108156" cy="10800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>
            <a:lumMod val="75000"/>
          </a:schemeClr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062083"/>
            <a:ext cx="9179799" cy="438666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6617911"/>
            <a:ext cx="8099822" cy="3042080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235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759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670833"/>
            <a:ext cx="2328699" cy="10677907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670833"/>
            <a:ext cx="6851100" cy="10677907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46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415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141251"/>
            <a:ext cx="9314796" cy="5241244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8432079"/>
            <a:ext cx="9314796" cy="27562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817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354163"/>
            <a:ext cx="4589899" cy="7994577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354163"/>
            <a:ext cx="4589899" cy="7994577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305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670836"/>
            <a:ext cx="9314796" cy="243541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088748"/>
            <a:ext cx="4568805" cy="1513748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4602496"/>
            <a:ext cx="4568805" cy="676957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088748"/>
            <a:ext cx="4591306" cy="1513748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4602496"/>
            <a:ext cx="4591306" cy="676957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902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825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498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839999"/>
            <a:ext cx="3483205" cy="293999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814168"/>
            <a:ext cx="5467380" cy="8954158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3779996"/>
            <a:ext cx="3483205" cy="7002911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641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839999"/>
            <a:ext cx="3483205" cy="2939997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814168"/>
            <a:ext cx="5467380" cy="8954158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3779996"/>
            <a:ext cx="3483205" cy="7002911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906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670836"/>
            <a:ext cx="9314796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354163"/>
            <a:ext cx="9314796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1678325"/>
            <a:ext cx="242994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311D2-98EC-4BA3-82B6-59383CFA9593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1678325"/>
            <a:ext cx="364492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1678325"/>
            <a:ext cx="242994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9DAD5-0586-4952-8202-D69038DE48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08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chart" Target="../charts/chart2.xml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>
            <a:extLst>
              <a:ext uri="{FF2B5EF4-FFF2-40B4-BE49-F238E27FC236}">
                <a16:creationId xmlns:a16="http://schemas.microsoft.com/office/drawing/2014/main" id="{01D21891-564F-D4F8-C99B-14AF7704B41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82" t="3840" r="16957" b="2023"/>
          <a:stretch/>
        </p:blipFill>
        <p:spPr>
          <a:xfrm>
            <a:off x="328300" y="797299"/>
            <a:ext cx="1618488" cy="1618488"/>
          </a:xfrm>
          <a:prstGeom prst="rect">
            <a:avLst/>
          </a:prstGeom>
        </p:spPr>
      </p:pic>
      <p:pic>
        <p:nvPicPr>
          <p:cNvPr id="54" name="Picture 8">
            <a:extLst>
              <a:ext uri="{FF2B5EF4-FFF2-40B4-BE49-F238E27FC236}">
                <a16:creationId xmlns:a16="http://schemas.microsoft.com/office/drawing/2014/main" id="{BA84C534-AA01-A516-424B-E94769FF033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01" t="2906" r="21714" b="3216"/>
          <a:stretch/>
        </p:blipFill>
        <p:spPr>
          <a:xfrm>
            <a:off x="328300" y="2417299"/>
            <a:ext cx="1618488" cy="1618488"/>
          </a:xfrm>
          <a:prstGeom prst="rect">
            <a:avLst/>
          </a:prstGeom>
        </p:spPr>
      </p:pic>
      <p:pic>
        <p:nvPicPr>
          <p:cNvPr id="55" name="Picture 27">
            <a:extLst>
              <a:ext uri="{FF2B5EF4-FFF2-40B4-BE49-F238E27FC236}">
                <a16:creationId xmlns:a16="http://schemas.microsoft.com/office/drawing/2014/main" id="{0A6DD8F7-9124-CDE4-42EE-E59BB08C328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60" t="4509" r="17502" b="1382"/>
          <a:stretch/>
        </p:blipFill>
        <p:spPr>
          <a:xfrm>
            <a:off x="2025250" y="797299"/>
            <a:ext cx="1618488" cy="1618488"/>
          </a:xfrm>
          <a:prstGeom prst="rect">
            <a:avLst/>
          </a:prstGeom>
        </p:spPr>
      </p:pic>
      <p:pic>
        <p:nvPicPr>
          <p:cNvPr id="56" name="Picture 35">
            <a:extLst>
              <a:ext uri="{FF2B5EF4-FFF2-40B4-BE49-F238E27FC236}">
                <a16:creationId xmlns:a16="http://schemas.microsoft.com/office/drawing/2014/main" id="{6C806C2D-674B-FA00-6B56-1135D06EEB3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63" t="3256" r="20698" b="2635"/>
          <a:stretch/>
        </p:blipFill>
        <p:spPr>
          <a:xfrm>
            <a:off x="2025250" y="2417299"/>
            <a:ext cx="1618488" cy="1618488"/>
          </a:xfrm>
          <a:prstGeom prst="rect">
            <a:avLst/>
          </a:prstGeom>
        </p:spPr>
      </p:pic>
      <p:pic>
        <p:nvPicPr>
          <p:cNvPr id="57" name="Picture 39">
            <a:extLst>
              <a:ext uri="{FF2B5EF4-FFF2-40B4-BE49-F238E27FC236}">
                <a16:creationId xmlns:a16="http://schemas.microsoft.com/office/drawing/2014/main" id="{03B1A769-3106-6536-00BA-B85D23B40DE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66" t="4033" r="20394" b="1704"/>
          <a:stretch/>
        </p:blipFill>
        <p:spPr>
          <a:xfrm>
            <a:off x="3645250" y="797299"/>
            <a:ext cx="1618488" cy="1618488"/>
          </a:xfrm>
          <a:prstGeom prst="rect">
            <a:avLst/>
          </a:prstGeom>
        </p:spPr>
      </p:pic>
      <p:pic>
        <p:nvPicPr>
          <p:cNvPr id="58" name="Picture 51">
            <a:extLst>
              <a:ext uri="{FF2B5EF4-FFF2-40B4-BE49-F238E27FC236}">
                <a16:creationId xmlns:a16="http://schemas.microsoft.com/office/drawing/2014/main" id="{8C6CDC34-2E93-E9BB-AC6D-32B6DD3ACA6C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40" t="1718" r="18329" b="4187"/>
          <a:stretch/>
        </p:blipFill>
        <p:spPr>
          <a:xfrm>
            <a:off x="3645250" y="2417299"/>
            <a:ext cx="1618488" cy="1618488"/>
          </a:xfrm>
          <a:prstGeom prst="rect">
            <a:avLst/>
          </a:prstGeom>
        </p:spPr>
      </p:pic>
      <p:sp>
        <p:nvSpPr>
          <p:cNvPr id="59" name="Szövegdoboz 58"/>
          <p:cNvSpPr txBox="1"/>
          <p:nvPr/>
        </p:nvSpPr>
        <p:spPr>
          <a:xfrm rot="16200000">
            <a:off x="-204863" y="1432443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Szövegdoboz 59"/>
          <p:cNvSpPr txBox="1"/>
          <p:nvPr/>
        </p:nvSpPr>
        <p:spPr>
          <a:xfrm rot="16200000">
            <a:off x="-285198" y="3050929"/>
            <a:ext cx="8836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 err="1" smtClean="0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B</a:t>
            </a:r>
            <a:endParaRPr 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Szövegdoboz 60"/>
          <p:cNvSpPr txBox="1"/>
          <p:nvPr/>
        </p:nvSpPr>
        <p:spPr>
          <a:xfrm>
            <a:off x="2069161" y="434899"/>
            <a:ext cx="15071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BOOH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8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Szövegdoboz 61"/>
          <p:cNvSpPr txBox="1"/>
          <p:nvPr/>
        </p:nvSpPr>
        <p:spPr>
          <a:xfrm>
            <a:off x="3697800" y="431573"/>
            <a:ext cx="1457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6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6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5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Szövegdoboz 62"/>
          <p:cNvSpPr txBox="1"/>
          <p:nvPr/>
        </p:nvSpPr>
        <p:spPr>
          <a:xfrm>
            <a:off x="474153" y="432745"/>
            <a:ext cx="1301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Picture 2">
            <a:extLst>
              <a:ext uri="{FF2B5EF4-FFF2-40B4-BE49-F238E27FC236}">
                <a16:creationId xmlns:a16="http://schemas.microsoft.com/office/drawing/2014/main" id="{92817BE1-A8E1-5BFB-D2C3-D0973EF038B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27" t="2480" r="19751" b="4186"/>
          <a:stretch/>
        </p:blipFill>
        <p:spPr>
          <a:xfrm>
            <a:off x="328300" y="5477433"/>
            <a:ext cx="1618488" cy="1618488"/>
          </a:xfrm>
          <a:prstGeom prst="rect">
            <a:avLst/>
          </a:prstGeom>
        </p:spPr>
      </p:pic>
      <p:pic>
        <p:nvPicPr>
          <p:cNvPr id="65" name="Picture 8">
            <a:extLst>
              <a:ext uri="{FF2B5EF4-FFF2-40B4-BE49-F238E27FC236}">
                <a16:creationId xmlns:a16="http://schemas.microsoft.com/office/drawing/2014/main" id="{BB2828A1-64D8-ED72-CB88-2B402E27A08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05" t="3876" r="20784" b="3256"/>
          <a:stretch/>
        </p:blipFill>
        <p:spPr>
          <a:xfrm>
            <a:off x="328300" y="7097433"/>
            <a:ext cx="1618488" cy="1618488"/>
          </a:xfrm>
          <a:prstGeom prst="rect">
            <a:avLst/>
          </a:prstGeom>
        </p:spPr>
      </p:pic>
      <p:pic>
        <p:nvPicPr>
          <p:cNvPr id="66" name="Picture 39">
            <a:extLst>
              <a:ext uri="{FF2B5EF4-FFF2-40B4-BE49-F238E27FC236}">
                <a16:creationId xmlns:a16="http://schemas.microsoft.com/office/drawing/2014/main" id="{F453E137-50A8-6436-2537-207D19E15A3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1" t="4470" r="19957" b="2661"/>
          <a:stretch/>
        </p:blipFill>
        <p:spPr>
          <a:xfrm>
            <a:off x="2025250" y="5477433"/>
            <a:ext cx="1618488" cy="1618488"/>
          </a:xfrm>
          <a:prstGeom prst="rect">
            <a:avLst/>
          </a:prstGeom>
        </p:spPr>
      </p:pic>
      <p:pic>
        <p:nvPicPr>
          <p:cNvPr id="67" name="Picture 51">
            <a:extLst>
              <a:ext uri="{FF2B5EF4-FFF2-40B4-BE49-F238E27FC236}">
                <a16:creationId xmlns:a16="http://schemas.microsoft.com/office/drawing/2014/main" id="{B6DF49D2-6CD9-F6F2-8694-FECEC4C408D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86" t="3849" r="17581" b="3101"/>
          <a:stretch/>
        </p:blipFill>
        <p:spPr>
          <a:xfrm>
            <a:off x="2025250" y="7097433"/>
            <a:ext cx="1618488" cy="1618488"/>
          </a:xfrm>
          <a:prstGeom prst="rect">
            <a:avLst/>
          </a:prstGeom>
        </p:spPr>
      </p:pic>
      <p:pic>
        <p:nvPicPr>
          <p:cNvPr id="68" name="Picture 8">
            <a:extLst>
              <a:ext uri="{FF2B5EF4-FFF2-40B4-BE49-F238E27FC236}">
                <a16:creationId xmlns:a16="http://schemas.microsoft.com/office/drawing/2014/main" id="{3CD37D3F-F85C-F594-4ABD-C517A9E54371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89" t="4031" r="21197" b="7598"/>
          <a:stretch/>
        </p:blipFill>
        <p:spPr>
          <a:xfrm>
            <a:off x="3645250" y="5477433"/>
            <a:ext cx="1618488" cy="1618488"/>
          </a:xfrm>
          <a:prstGeom prst="rect">
            <a:avLst/>
          </a:prstGeom>
        </p:spPr>
      </p:pic>
      <p:pic>
        <p:nvPicPr>
          <p:cNvPr id="69" name="Picture 13">
            <a:extLst>
              <a:ext uri="{FF2B5EF4-FFF2-40B4-BE49-F238E27FC236}">
                <a16:creationId xmlns:a16="http://schemas.microsoft.com/office/drawing/2014/main" id="{01500047-EB3C-9A4C-BA0B-9EE3655A4B52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17" t="5866" r="20371" b="5917"/>
          <a:stretch/>
        </p:blipFill>
        <p:spPr>
          <a:xfrm>
            <a:off x="3645250" y="7097433"/>
            <a:ext cx="1618488" cy="1618488"/>
          </a:xfrm>
          <a:prstGeom prst="rect">
            <a:avLst/>
          </a:prstGeom>
        </p:spPr>
      </p:pic>
      <p:sp>
        <p:nvSpPr>
          <p:cNvPr id="70" name="Szövegdoboz 69"/>
          <p:cNvSpPr txBox="1"/>
          <p:nvPr/>
        </p:nvSpPr>
        <p:spPr>
          <a:xfrm>
            <a:off x="2110421" y="5135560"/>
            <a:ext cx="140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Cl</a:t>
            </a:r>
            <a:r>
              <a:rPr lang="en-US" sz="16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2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Szövegdoboz 70"/>
          <p:cNvSpPr txBox="1"/>
          <p:nvPr/>
        </p:nvSpPr>
        <p:spPr>
          <a:xfrm>
            <a:off x="3798177" y="5132234"/>
            <a:ext cx="12382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FP (1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Szövegdoboz 71"/>
          <p:cNvSpPr txBox="1"/>
          <p:nvPr/>
        </p:nvSpPr>
        <p:spPr>
          <a:xfrm>
            <a:off x="464917" y="5133406"/>
            <a:ext cx="13015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Szövegdoboz 72"/>
          <p:cNvSpPr txBox="1"/>
          <p:nvPr/>
        </p:nvSpPr>
        <p:spPr>
          <a:xfrm rot="16200000">
            <a:off x="-207737" y="6174088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Szövegdoboz 73"/>
          <p:cNvSpPr txBox="1"/>
          <p:nvPr/>
        </p:nvSpPr>
        <p:spPr>
          <a:xfrm rot="16200000">
            <a:off x="-288072" y="7792574"/>
            <a:ext cx="8836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i="1" dirty="0" err="1" smtClean="0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6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B</a:t>
            </a:r>
            <a:endParaRPr 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6" name="Diagram 7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1014818"/>
              </p:ext>
            </p:extLst>
          </p:nvPr>
        </p:nvGraphicFramePr>
        <p:xfrm>
          <a:off x="5688622" y="4786078"/>
          <a:ext cx="5004141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77" name="Diagram 7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8895966"/>
              </p:ext>
            </p:extLst>
          </p:nvPr>
        </p:nvGraphicFramePr>
        <p:xfrm>
          <a:off x="5688622" y="138274"/>
          <a:ext cx="4999659" cy="43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78" name="Téglalap 77"/>
          <p:cNvSpPr/>
          <p:nvPr/>
        </p:nvSpPr>
        <p:spPr>
          <a:xfrm>
            <a:off x="315964" y="9538166"/>
            <a:ext cx="1020445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4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ress tolerance attributes of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fumigatu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 (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VKmeaB1 (</a:t>
            </a:r>
            <a:r>
              <a:rPr lang="en-US" i="1" dirty="0" err="1" smtClean="0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B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strains.</a:t>
            </a:r>
          </a:p>
          <a:p>
            <a:pPr algn="just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 A-B: Representative photos of 5-day-old cultures. Diameter of the Petri-dish used was 85 mm (the carbon and nitrogen sources were glucose and NaNO</a:t>
            </a:r>
            <a:r>
              <a:rPr lang="en-US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H = 6.5).</a:t>
            </a:r>
          </a:p>
          <a:p>
            <a:pPr algn="just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s C-D: Colony diameters (mean ± SD, n = 3). No significant difference (Student’s t-test,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 was found between the two strains at any culturing conditions.</a:t>
            </a:r>
          </a:p>
          <a:p>
            <a:pPr algn="just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Szövegdoboz 1"/>
          <p:cNvSpPr txBox="1"/>
          <p:nvPr/>
        </p:nvSpPr>
        <p:spPr>
          <a:xfrm>
            <a:off x="153744" y="26531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Szövegdoboz 78"/>
          <p:cNvSpPr txBox="1"/>
          <p:nvPr/>
        </p:nvSpPr>
        <p:spPr>
          <a:xfrm>
            <a:off x="153744" y="49153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Szövegdoboz 79"/>
          <p:cNvSpPr txBox="1"/>
          <p:nvPr/>
        </p:nvSpPr>
        <p:spPr>
          <a:xfrm>
            <a:off x="5688622" y="2658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Szövegdoboz 80"/>
          <p:cNvSpPr txBox="1"/>
          <p:nvPr/>
        </p:nvSpPr>
        <p:spPr>
          <a:xfrm>
            <a:off x="5688622" y="50006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2387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393</TotalTime>
  <Words>149</Words>
  <Application>Microsoft Office PowerPoint</Application>
  <PresentationFormat>Egyéni</PresentationFormat>
  <Paragraphs>26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fumigatus CRISPR-CAS9  gfp-332 plasmid 2nd transf</dc:title>
  <dc:creator>Varga Kinga Edina</dc:creator>
  <cp:lastModifiedBy>Tanar</cp:lastModifiedBy>
  <cp:revision>19</cp:revision>
  <dcterms:created xsi:type="dcterms:W3CDTF">2022-08-22T08:28:16Z</dcterms:created>
  <dcterms:modified xsi:type="dcterms:W3CDTF">2025-03-30T17:46:18Z</dcterms:modified>
</cp:coreProperties>
</file>